
<file path=[Content_Types].xml><?xml version="1.0" encoding="utf-8"?>
<Types xmlns="http://schemas.openxmlformats.org/package/2006/content-types">
  <Default Extension="jfif" ContentType="image/jpeg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61" r:id="rId4"/>
    <p:sldId id="262" r:id="rId5"/>
    <p:sldId id="263" r:id="rId6"/>
    <p:sldId id="264" r:id="rId7"/>
    <p:sldId id="265" r:id="rId8"/>
    <p:sldId id="266" r:id="rId9"/>
    <p:sldId id="267" r:id="rId10"/>
    <p:sldId id="268" r:id="rId11"/>
    <p:sldId id="270" r:id="rId12"/>
    <p:sldId id="272" r:id="rId13"/>
    <p:sldId id="271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79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5_3">
  <dgm:title val=""/>
  <dgm:desc val=""/>
  <dgm:catLst>
    <dgm:cat type="accent5" pri="11300"/>
  </dgm:catLst>
  <dgm:styleLbl name="node0">
    <dgm:fillClrLst meth="repeat">
      <a:schemeClr val="accent5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>
        <a:shade val="80000"/>
      </a:schemeClr>
      <a:schemeClr val="accent5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>
        <a:shade val="80000"/>
      </a:schemeClr>
      <a:schemeClr val="accent5">
        <a:tint val="70000"/>
      </a:schemeClr>
    </dgm:fillClrLst>
    <dgm:linClrLst>
      <a:schemeClr val="accent5">
        <a:shade val="80000"/>
      </a:schemeClr>
      <a:schemeClr val="accent5">
        <a:tint val="70000"/>
      </a:schemeClr>
    </dgm:linClrLst>
    <dgm:effectClrLst/>
    <dgm:txLinClrLst/>
    <dgm:txFillClrLst/>
    <dgm:txEffectClrLst/>
  </dgm:styleLbl>
  <dgm:styleLbl name="lnNode1">
    <dgm:fillClrLst>
      <a:schemeClr val="accent5">
        <a:shade val="80000"/>
      </a:schemeClr>
      <a:schemeClr val="accent5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shade val="80000"/>
        <a:alpha val="50000"/>
      </a:schemeClr>
      <a:schemeClr val="accent5">
        <a:tint val="70000"/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5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5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5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5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5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5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>
        <a:shade val="90000"/>
      </a:schemeClr>
      <a:schemeClr val="accent5">
        <a:tint val="70000"/>
      </a:schemeClr>
    </dgm:fillClrLst>
    <dgm:linClrLst>
      <a:schemeClr val="accent5">
        <a:shade val="90000"/>
      </a:schemeClr>
      <a:schemeClr val="accent5">
        <a:tint val="70000"/>
      </a:schemeClr>
    </dgm:linClrLst>
    <dgm:effectClrLst/>
    <dgm:txLinClrLst/>
    <dgm:txFillClrLst/>
    <dgm:txEffectClrLst/>
  </dgm:styleLbl>
  <dgm:styleLbl name="fgSibTrans2D1">
    <dgm:fillClrLst>
      <a:schemeClr val="accent5">
        <a:shade val="90000"/>
      </a:schemeClr>
      <a:schemeClr val="accent5">
        <a:tint val="70000"/>
      </a:schemeClr>
    </dgm:fillClrLst>
    <dgm:linClrLst>
      <a:schemeClr val="accent5">
        <a:shade val="90000"/>
      </a:schemeClr>
      <a:schemeClr val="accent5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>
        <a:shade val="90000"/>
      </a:schemeClr>
      <a:schemeClr val="accent5">
        <a:tint val="70000"/>
      </a:schemeClr>
    </dgm:fillClrLst>
    <dgm:linClrLst>
      <a:schemeClr val="accent5">
        <a:shade val="90000"/>
      </a:schemeClr>
      <a:schemeClr val="accent5">
        <a:tint val="70000"/>
      </a:schemeClr>
    </dgm:linClrLst>
    <dgm:effectClrLst/>
    <dgm:txLinClrLst/>
    <dgm:txFillClrLst meth="repeat">
      <a:schemeClr val="lt1"/>
    </dgm:txFillClrLst>
    <dgm:txEffectClrLst/>
  </dgm:styleLbl>
  <dgm:styleLbl name="sibTrans1D1">
    <dgm:fillClrLst>
      <a:schemeClr val="accent5">
        <a:shade val="90000"/>
      </a:schemeClr>
      <a:schemeClr val="accent5">
        <a:tint val="70000"/>
      </a:schemeClr>
    </dgm:fillClrLst>
    <dgm:linClrLst>
      <a:schemeClr val="accent5">
        <a:shade val="90000"/>
      </a:schemeClr>
      <a:schemeClr val="accent5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5">
        <a:shade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5">
        <a:tint val="99000"/>
      </a:schemeClr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5">
        <a:tint val="80000"/>
      </a:schemeClr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5">
        <a:tint val="70000"/>
      </a:schemeClr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>
        <a:tint val="60000"/>
      </a:schemeClr>
    </dgm:fillClrLst>
    <dgm:linClrLst meth="repeat">
      <a:schemeClr val="accent5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5">
        <a:tint val="90000"/>
      </a:schemeClr>
    </dgm:fillClrLst>
    <dgm:linClrLst meth="repeat">
      <a:schemeClr val="accent5">
        <a:tint val="90000"/>
      </a:schemeClr>
    </dgm:linClrLst>
    <dgm:effectClrLst/>
    <dgm:txLinClrLst/>
    <dgm:txFillClrLst/>
    <dgm:txEffectClrLst/>
  </dgm:styleLbl>
  <dgm:styleLbl name="parChTrans2D3">
    <dgm:fillClrLst meth="repeat">
      <a:schemeClr val="accent5">
        <a:tint val="70000"/>
      </a:schemeClr>
    </dgm:fillClrLst>
    <dgm:linClrLst meth="repeat">
      <a:schemeClr val="accent5">
        <a:tint val="70000"/>
      </a:schemeClr>
    </dgm:linClrLst>
    <dgm:effectClrLst/>
    <dgm:txLinClrLst/>
    <dgm:txFillClrLst/>
    <dgm:txEffectClrLst/>
  </dgm:styleLbl>
  <dgm:styleLbl name="parChTrans2D4">
    <dgm:fillClrLst meth="repeat">
      <a:schemeClr val="accent5">
        <a:tint val="50000"/>
      </a:schemeClr>
    </dgm:fillClrLst>
    <dgm:linClrLst meth="repeat">
      <a:schemeClr val="accent5">
        <a:tint val="50000"/>
      </a:schemeClr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>
        <a:shade val="80000"/>
      </a:schemeClr>
    </dgm:fillClrLst>
    <dgm:linClrLst meth="repeat">
      <a:schemeClr val="accent5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5">
        <a:tint val="99000"/>
      </a:schemeClr>
    </dgm:fillClrLst>
    <dgm:linClrLst meth="repeat">
      <a:schemeClr val="accent5">
        <a:tint val="99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5">
        <a:tint val="80000"/>
      </a:schemeClr>
    </dgm:fillClrLst>
    <dgm:linClrLst meth="repeat">
      <a:schemeClr val="accent5">
        <a:tint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5">
        <a:tint val="70000"/>
      </a:schemeClr>
    </dgm:fillClrLst>
    <dgm:linClrLst meth="repeat">
      <a:schemeClr val="accent5">
        <a:tint val="7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>
        <a:shade val="80000"/>
      </a:schemeClr>
      <a:schemeClr val="accent5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>
        <a:shade val="80000"/>
      </a:schemeClr>
      <a:schemeClr val="accent5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>
        <a:shade val="80000"/>
      </a:schemeClr>
      <a:schemeClr val="accent5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>
        <a:shade val="80000"/>
      </a:schemeClr>
      <a:schemeClr val="accent5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>
        <a:shade val="80000"/>
      </a:schemeClr>
      <a:schemeClr val="accent5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5">
        <a:alpha val="90000"/>
        <a:tint val="40000"/>
      </a:schemeClr>
    </dgm:fillClrLst>
    <dgm:linClrLst meth="repeat">
      <a:schemeClr val="accent5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5">
        <a:alpha val="90000"/>
        <a:tint val="40000"/>
      </a:schemeClr>
    </dgm:fillClrLst>
    <dgm:linClrLst meth="repeat">
      <a:schemeClr val="accent5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5">
        <a:alpha val="90000"/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5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5">
        <a:tint val="99000"/>
      </a:schemeClr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5">
        <a:tint val="80000"/>
      </a:schemeClr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5">
        <a:tint val="70000"/>
      </a:schemeClr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E762C252-98A1-497D-919F-DAFDEC46D2B2}" type="doc">
      <dgm:prSet loTypeId="urn:microsoft.com/office/officeart/2005/8/layout/pyramid1" loCatId="pyramid" qsTypeId="urn:microsoft.com/office/officeart/2005/8/quickstyle/simple2" qsCatId="simple" csTypeId="urn:microsoft.com/office/officeart/2005/8/colors/accent5_3" csCatId="accent5" phldr="1"/>
      <dgm:spPr/>
    </dgm:pt>
    <dgm:pt modelId="{ECC94DE3-A5F2-4819-A353-9B3C810F44B6}">
      <dgm:prSet phldrT="[Text]" custT="1"/>
      <dgm:spPr/>
      <dgm:t>
        <a:bodyPr/>
        <a:lstStyle/>
        <a:p>
          <a:r>
            <a:rPr lang="ar-SY" sz="1400" b="1" dirty="0"/>
            <a:t>تقارير حالات</a:t>
          </a:r>
          <a:endParaRPr lang="en-US" sz="1400" b="1" dirty="0"/>
        </a:p>
      </dgm:t>
    </dgm:pt>
    <dgm:pt modelId="{DE7D661A-63E1-438F-993D-AF092FE57F04}" type="parTrans" cxnId="{853AD1A7-A969-4595-BACE-CB723B366822}">
      <dgm:prSet/>
      <dgm:spPr/>
      <dgm:t>
        <a:bodyPr/>
        <a:lstStyle/>
        <a:p>
          <a:endParaRPr lang="en-US"/>
        </a:p>
      </dgm:t>
    </dgm:pt>
    <dgm:pt modelId="{E1014FED-BD02-4827-B92D-CAF0C2EFC5B6}" type="sibTrans" cxnId="{853AD1A7-A969-4595-BACE-CB723B366822}">
      <dgm:prSet/>
      <dgm:spPr/>
      <dgm:t>
        <a:bodyPr/>
        <a:lstStyle/>
        <a:p>
          <a:endParaRPr lang="en-US"/>
        </a:p>
      </dgm:t>
    </dgm:pt>
    <dgm:pt modelId="{3D3038A7-59CF-4596-AA4F-38B12853EC5D}">
      <dgm:prSet phldrT="[Text]" custT="1"/>
      <dgm:spPr/>
      <dgm:t>
        <a:bodyPr/>
        <a:lstStyle/>
        <a:p>
          <a:r>
            <a:rPr lang="ar-SY" sz="1400" b="1" dirty="0"/>
            <a:t>رأي الخبراء</a:t>
          </a:r>
          <a:endParaRPr lang="en-US" sz="1400" b="1" dirty="0"/>
        </a:p>
      </dgm:t>
    </dgm:pt>
    <dgm:pt modelId="{679D0C2D-D02C-4C7B-A9C6-94A7BEA121DF}" type="parTrans" cxnId="{F163E73D-7D31-4853-B74F-75C876908B2F}">
      <dgm:prSet/>
      <dgm:spPr/>
      <dgm:t>
        <a:bodyPr/>
        <a:lstStyle/>
        <a:p>
          <a:endParaRPr lang="en-US"/>
        </a:p>
      </dgm:t>
    </dgm:pt>
    <dgm:pt modelId="{A5F62FDE-6607-49C8-96BD-4CC04BFF909B}" type="sibTrans" cxnId="{F163E73D-7D31-4853-B74F-75C876908B2F}">
      <dgm:prSet/>
      <dgm:spPr/>
      <dgm:t>
        <a:bodyPr/>
        <a:lstStyle/>
        <a:p>
          <a:endParaRPr lang="en-US"/>
        </a:p>
      </dgm:t>
    </dgm:pt>
    <dgm:pt modelId="{5EA83D5F-1F4E-4B08-82CE-EEEABE7EC1C6}">
      <dgm:prSet phldrT="[Text]" custT="1"/>
      <dgm:spPr/>
      <dgm:t>
        <a:bodyPr/>
        <a:lstStyle/>
        <a:p>
          <a:r>
            <a:rPr lang="ar-SY" sz="1400" b="1"/>
            <a:t>الدراسات</a:t>
          </a:r>
          <a:r>
            <a:rPr lang="ar-SY" sz="1200" b="1"/>
            <a:t> </a:t>
          </a:r>
          <a:r>
            <a:rPr lang="ar-SY" sz="1400" b="1"/>
            <a:t>الحشدية</a:t>
          </a:r>
          <a:endParaRPr lang="en-US" sz="1200" b="1"/>
        </a:p>
      </dgm:t>
    </dgm:pt>
    <dgm:pt modelId="{84861E9C-09B2-4603-A93E-DAF0D4B67CBD}" type="parTrans" cxnId="{C21E103A-C588-4DD3-A505-D53BBFE1F270}">
      <dgm:prSet/>
      <dgm:spPr/>
      <dgm:t>
        <a:bodyPr/>
        <a:lstStyle/>
        <a:p>
          <a:endParaRPr lang="en-US"/>
        </a:p>
      </dgm:t>
    </dgm:pt>
    <dgm:pt modelId="{21B4D78D-C15A-4847-A09A-B0B7FA3E12F1}" type="sibTrans" cxnId="{C21E103A-C588-4DD3-A505-D53BBFE1F270}">
      <dgm:prSet/>
      <dgm:spPr/>
      <dgm:t>
        <a:bodyPr/>
        <a:lstStyle/>
        <a:p>
          <a:endParaRPr lang="en-US"/>
        </a:p>
      </dgm:t>
    </dgm:pt>
    <dgm:pt modelId="{23A81959-9DAF-4A66-A931-434B4D68B2CE}">
      <dgm:prSet phldrT="[Text]" custT="1"/>
      <dgm:spPr/>
      <dgm:t>
        <a:bodyPr/>
        <a:lstStyle/>
        <a:p>
          <a:r>
            <a:rPr lang="ar-SY" sz="1400" b="1" dirty="0"/>
            <a:t>دراسة مراقبة الحالات والشواهد</a:t>
          </a:r>
          <a:endParaRPr lang="en-US" sz="1400" b="1" dirty="0"/>
        </a:p>
      </dgm:t>
    </dgm:pt>
    <dgm:pt modelId="{6CBB977C-4393-4220-B6F8-13EF0EE740C8}" type="parTrans" cxnId="{ED0471F2-0366-4079-8661-2BCBD17A36B6}">
      <dgm:prSet/>
      <dgm:spPr/>
      <dgm:t>
        <a:bodyPr/>
        <a:lstStyle/>
        <a:p>
          <a:endParaRPr lang="en-US"/>
        </a:p>
      </dgm:t>
    </dgm:pt>
    <dgm:pt modelId="{4090513E-EBF8-40A2-A921-F896A0836985}" type="sibTrans" cxnId="{ED0471F2-0366-4079-8661-2BCBD17A36B6}">
      <dgm:prSet/>
      <dgm:spPr/>
      <dgm:t>
        <a:bodyPr/>
        <a:lstStyle/>
        <a:p>
          <a:endParaRPr lang="en-US"/>
        </a:p>
      </dgm:t>
    </dgm:pt>
    <dgm:pt modelId="{B29F69BE-E11B-4DCF-B9F2-CBB9F0B6B047}">
      <dgm:prSet phldrT="[Text]" custT="1"/>
      <dgm:spPr/>
      <dgm:t>
        <a:bodyPr/>
        <a:lstStyle/>
        <a:p>
          <a:r>
            <a:rPr lang="ar-SY" sz="1400" b="1"/>
            <a:t>تقرير حالة</a:t>
          </a:r>
          <a:endParaRPr lang="en-US" sz="1400" b="1"/>
        </a:p>
      </dgm:t>
    </dgm:pt>
    <dgm:pt modelId="{54FC7A0A-61D1-423D-9EBC-574BDB3D5B3A}" type="parTrans" cxnId="{E8C58D8B-DC9C-4D0B-AFC1-2DD31C7B6859}">
      <dgm:prSet/>
      <dgm:spPr/>
      <dgm:t>
        <a:bodyPr/>
        <a:lstStyle/>
        <a:p>
          <a:endParaRPr lang="en-US"/>
        </a:p>
      </dgm:t>
    </dgm:pt>
    <dgm:pt modelId="{3FCFF8DF-7049-41B4-9A01-D493F95FA7A8}" type="sibTrans" cxnId="{E8C58D8B-DC9C-4D0B-AFC1-2DD31C7B6859}">
      <dgm:prSet/>
      <dgm:spPr/>
      <dgm:t>
        <a:bodyPr/>
        <a:lstStyle/>
        <a:p>
          <a:endParaRPr lang="en-US"/>
        </a:p>
      </dgm:t>
    </dgm:pt>
    <dgm:pt modelId="{2CD770A5-8CCE-473E-8759-5710AD59A9C5}">
      <dgm:prSet phldrT="[Text]" custT="1"/>
      <dgm:spPr/>
      <dgm:t>
        <a:bodyPr/>
        <a:lstStyle/>
        <a:p>
          <a:r>
            <a:rPr lang="ar-SY" sz="1400" b="1" dirty="0"/>
            <a:t>التجارب السريرية العشوائية ذات الشواهد</a:t>
          </a:r>
          <a:endParaRPr lang="en-US" sz="1400" b="1" dirty="0"/>
        </a:p>
      </dgm:t>
    </dgm:pt>
    <dgm:pt modelId="{5941C607-6913-4866-9BED-8CE364745D66}" type="sibTrans" cxnId="{FE61D5E6-AB9D-42ED-B315-99F3F86659B2}">
      <dgm:prSet/>
      <dgm:spPr/>
      <dgm:t>
        <a:bodyPr/>
        <a:lstStyle/>
        <a:p>
          <a:endParaRPr lang="en-US"/>
        </a:p>
      </dgm:t>
    </dgm:pt>
    <dgm:pt modelId="{C75148B3-5216-401C-909A-97448EBE5BE9}" type="parTrans" cxnId="{FE61D5E6-AB9D-42ED-B315-99F3F86659B2}">
      <dgm:prSet/>
      <dgm:spPr/>
      <dgm:t>
        <a:bodyPr/>
        <a:lstStyle/>
        <a:p>
          <a:endParaRPr lang="en-US"/>
        </a:p>
      </dgm:t>
    </dgm:pt>
    <dgm:pt modelId="{F96D4AB5-27E5-449A-A474-0E563B8323CC}">
      <dgm:prSet phldrT="[Text]" custT="1"/>
      <dgm:spPr/>
      <dgm:t>
        <a:bodyPr/>
        <a:lstStyle/>
        <a:p>
          <a:r>
            <a:rPr lang="ar-SY" sz="1400" b="1"/>
            <a:t>الدراسات على الحيوانات</a:t>
          </a:r>
          <a:endParaRPr lang="en-US" sz="1400" b="1"/>
        </a:p>
      </dgm:t>
    </dgm:pt>
    <dgm:pt modelId="{9575EC6D-41E4-41BE-9C9A-E2E2E1A930B9}" type="parTrans" cxnId="{AF9C41C0-D52D-492C-A9F3-83D86D24565F}">
      <dgm:prSet/>
      <dgm:spPr/>
      <dgm:t>
        <a:bodyPr/>
        <a:lstStyle/>
        <a:p>
          <a:endParaRPr lang="en-US"/>
        </a:p>
      </dgm:t>
    </dgm:pt>
    <dgm:pt modelId="{98E66F92-DC86-46A3-B44B-DA1E6656B40F}" type="sibTrans" cxnId="{AF9C41C0-D52D-492C-A9F3-83D86D24565F}">
      <dgm:prSet/>
      <dgm:spPr/>
      <dgm:t>
        <a:bodyPr/>
        <a:lstStyle/>
        <a:p>
          <a:endParaRPr lang="en-US"/>
        </a:p>
      </dgm:t>
    </dgm:pt>
    <dgm:pt modelId="{E3228412-3359-44F6-BEC4-5F99FCC39DBF}">
      <dgm:prSet phldrT="[Text]" custT="1"/>
      <dgm:spPr/>
      <dgm:t>
        <a:bodyPr/>
        <a:lstStyle/>
        <a:p>
          <a:r>
            <a:rPr lang="ar-SY" sz="1400" b="1"/>
            <a:t>الدراسات في المخبر</a:t>
          </a:r>
          <a:endParaRPr lang="en-US" sz="1400" b="1"/>
        </a:p>
      </dgm:t>
    </dgm:pt>
    <dgm:pt modelId="{C801C87D-9711-47CD-972D-F1F17680A1AF}" type="parTrans" cxnId="{62D0A2B9-8241-4BFC-8129-975119A3BA8E}">
      <dgm:prSet/>
      <dgm:spPr/>
      <dgm:t>
        <a:bodyPr/>
        <a:lstStyle/>
        <a:p>
          <a:endParaRPr lang="en-US"/>
        </a:p>
      </dgm:t>
    </dgm:pt>
    <dgm:pt modelId="{5DAC7549-C2AD-4C07-AA12-F302339C5DBA}" type="sibTrans" cxnId="{62D0A2B9-8241-4BFC-8129-975119A3BA8E}">
      <dgm:prSet/>
      <dgm:spPr/>
      <dgm:t>
        <a:bodyPr/>
        <a:lstStyle/>
        <a:p>
          <a:endParaRPr lang="en-US"/>
        </a:p>
      </dgm:t>
    </dgm:pt>
    <dgm:pt modelId="{D4A27A54-F805-4733-ACFD-480773DFFFC3}" type="pres">
      <dgm:prSet presAssocID="{E762C252-98A1-497D-919F-DAFDEC46D2B2}" presName="Name0" presStyleCnt="0">
        <dgm:presLayoutVars>
          <dgm:dir/>
          <dgm:animLvl val="lvl"/>
          <dgm:resizeHandles val="exact"/>
        </dgm:presLayoutVars>
      </dgm:prSet>
      <dgm:spPr/>
    </dgm:pt>
    <dgm:pt modelId="{3EB60814-3901-490A-8A12-82C6AC32D15E}" type="pres">
      <dgm:prSet presAssocID="{2CD770A5-8CCE-473E-8759-5710AD59A9C5}" presName="Name8" presStyleCnt="0"/>
      <dgm:spPr/>
    </dgm:pt>
    <dgm:pt modelId="{D8056657-2F28-450B-B42C-D134123F4288}" type="pres">
      <dgm:prSet presAssocID="{2CD770A5-8CCE-473E-8759-5710AD59A9C5}" presName="level" presStyleLbl="node1" presStyleIdx="0" presStyleCnt="8" custScaleX="109886" custScaleY="154093">
        <dgm:presLayoutVars>
          <dgm:chMax val="1"/>
          <dgm:bulletEnabled val="1"/>
        </dgm:presLayoutVars>
      </dgm:prSet>
      <dgm:spPr/>
    </dgm:pt>
    <dgm:pt modelId="{A288E0E0-72EA-4844-ADBD-17BB8359F24D}" type="pres">
      <dgm:prSet presAssocID="{2CD770A5-8CCE-473E-8759-5710AD59A9C5}" presName="levelTx" presStyleLbl="revTx" presStyleIdx="0" presStyleCnt="0">
        <dgm:presLayoutVars>
          <dgm:chMax val="1"/>
          <dgm:bulletEnabled val="1"/>
        </dgm:presLayoutVars>
      </dgm:prSet>
      <dgm:spPr/>
    </dgm:pt>
    <dgm:pt modelId="{0323997A-69AE-4D5B-ABA5-1A6D3E0639D5}" type="pres">
      <dgm:prSet presAssocID="{5EA83D5F-1F4E-4B08-82CE-EEEABE7EC1C6}" presName="Name8" presStyleCnt="0"/>
      <dgm:spPr/>
    </dgm:pt>
    <dgm:pt modelId="{366F6834-4A90-4A1C-9593-CDA1B22061F7}" type="pres">
      <dgm:prSet presAssocID="{5EA83D5F-1F4E-4B08-82CE-EEEABE7EC1C6}" presName="level" presStyleLbl="node1" presStyleIdx="1" presStyleCnt="8" custScaleY="70292">
        <dgm:presLayoutVars>
          <dgm:chMax val="1"/>
          <dgm:bulletEnabled val="1"/>
        </dgm:presLayoutVars>
      </dgm:prSet>
      <dgm:spPr/>
    </dgm:pt>
    <dgm:pt modelId="{91C49125-F316-4C05-9F0A-0DEC7F770452}" type="pres">
      <dgm:prSet presAssocID="{5EA83D5F-1F4E-4B08-82CE-EEEABE7EC1C6}" presName="levelTx" presStyleLbl="revTx" presStyleIdx="0" presStyleCnt="0">
        <dgm:presLayoutVars>
          <dgm:chMax val="1"/>
          <dgm:bulletEnabled val="1"/>
        </dgm:presLayoutVars>
      </dgm:prSet>
      <dgm:spPr/>
    </dgm:pt>
    <dgm:pt modelId="{16D21530-214B-4D60-8F72-9456FC8EEA7E}" type="pres">
      <dgm:prSet presAssocID="{23A81959-9DAF-4A66-A931-434B4D68B2CE}" presName="Name8" presStyleCnt="0"/>
      <dgm:spPr/>
    </dgm:pt>
    <dgm:pt modelId="{52F230A4-46F3-4C56-AB1E-AC9A318F0B1D}" type="pres">
      <dgm:prSet presAssocID="{23A81959-9DAF-4A66-A931-434B4D68B2CE}" presName="level" presStyleLbl="node1" presStyleIdx="2" presStyleCnt="8">
        <dgm:presLayoutVars>
          <dgm:chMax val="1"/>
          <dgm:bulletEnabled val="1"/>
        </dgm:presLayoutVars>
      </dgm:prSet>
      <dgm:spPr/>
    </dgm:pt>
    <dgm:pt modelId="{1E4848D2-13D5-4416-B98A-EE648758EE7C}" type="pres">
      <dgm:prSet presAssocID="{23A81959-9DAF-4A66-A931-434B4D68B2CE}" presName="levelTx" presStyleLbl="revTx" presStyleIdx="0" presStyleCnt="0">
        <dgm:presLayoutVars>
          <dgm:chMax val="1"/>
          <dgm:bulletEnabled val="1"/>
        </dgm:presLayoutVars>
      </dgm:prSet>
      <dgm:spPr/>
    </dgm:pt>
    <dgm:pt modelId="{43464430-AB15-4C68-B50E-A635B390C6AE}" type="pres">
      <dgm:prSet presAssocID="{ECC94DE3-A5F2-4819-A353-9B3C810F44B6}" presName="Name8" presStyleCnt="0"/>
      <dgm:spPr/>
    </dgm:pt>
    <dgm:pt modelId="{BF6D9866-EBC3-4B0B-9CF5-B105A23975E6}" type="pres">
      <dgm:prSet presAssocID="{ECC94DE3-A5F2-4819-A353-9B3C810F44B6}" presName="level" presStyleLbl="node1" presStyleIdx="3" presStyleCnt="8">
        <dgm:presLayoutVars>
          <dgm:chMax val="1"/>
          <dgm:bulletEnabled val="1"/>
        </dgm:presLayoutVars>
      </dgm:prSet>
      <dgm:spPr/>
    </dgm:pt>
    <dgm:pt modelId="{51637772-85AE-4A8B-B982-A9E30FB56790}" type="pres">
      <dgm:prSet presAssocID="{ECC94DE3-A5F2-4819-A353-9B3C810F44B6}" presName="levelTx" presStyleLbl="revTx" presStyleIdx="0" presStyleCnt="0">
        <dgm:presLayoutVars>
          <dgm:chMax val="1"/>
          <dgm:bulletEnabled val="1"/>
        </dgm:presLayoutVars>
      </dgm:prSet>
      <dgm:spPr/>
    </dgm:pt>
    <dgm:pt modelId="{134E3235-B25D-48C7-9DDD-ABB5E1D38E41}" type="pres">
      <dgm:prSet presAssocID="{B29F69BE-E11B-4DCF-B9F2-CBB9F0B6B047}" presName="Name8" presStyleCnt="0"/>
      <dgm:spPr/>
    </dgm:pt>
    <dgm:pt modelId="{95AC4F6E-E2A0-4BD3-92BD-5152E4140CCF}" type="pres">
      <dgm:prSet presAssocID="{B29F69BE-E11B-4DCF-B9F2-CBB9F0B6B047}" presName="level" presStyleLbl="node1" presStyleIdx="4" presStyleCnt="8">
        <dgm:presLayoutVars>
          <dgm:chMax val="1"/>
          <dgm:bulletEnabled val="1"/>
        </dgm:presLayoutVars>
      </dgm:prSet>
      <dgm:spPr/>
    </dgm:pt>
    <dgm:pt modelId="{32EA77F0-298B-416A-96F0-D96662EED690}" type="pres">
      <dgm:prSet presAssocID="{B29F69BE-E11B-4DCF-B9F2-CBB9F0B6B047}" presName="levelTx" presStyleLbl="revTx" presStyleIdx="0" presStyleCnt="0">
        <dgm:presLayoutVars>
          <dgm:chMax val="1"/>
          <dgm:bulletEnabled val="1"/>
        </dgm:presLayoutVars>
      </dgm:prSet>
      <dgm:spPr/>
    </dgm:pt>
    <dgm:pt modelId="{2CB3E8AB-F903-4A6C-916E-428EEF96FBE4}" type="pres">
      <dgm:prSet presAssocID="{F96D4AB5-27E5-449A-A474-0E563B8323CC}" presName="Name8" presStyleCnt="0"/>
      <dgm:spPr/>
    </dgm:pt>
    <dgm:pt modelId="{8A1F90FE-AA88-4709-AA45-907D19FFAD34}" type="pres">
      <dgm:prSet presAssocID="{F96D4AB5-27E5-449A-A474-0E563B8323CC}" presName="level" presStyleLbl="node1" presStyleIdx="5" presStyleCnt="8">
        <dgm:presLayoutVars>
          <dgm:chMax val="1"/>
          <dgm:bulletEnabled val="1"/>
        </dgm:presLayoutVars>
      </dgm:prSet>
      <dgm:spPr/>
    </dgm:pt>
    <dgm:pt modelId="{AD11D3CE-56F9-4089-ADFB-B29A70C9749E}" type="pres">
      <dgm:prSet presAssocID="{F96D4AB5-27E5-449A-A474-0E563B8323CC}" presName="levelTx" presStyleLbl="revTx" presStyleIdx="0" presStyleCnt="0">
        <dgm:presLayoutVars>
          <dgm:chMax val="1"/>
          <dgm:bulletEnabled val="1"/>
        </dgm:presLayoutVars>
      </dgm:prSet>
      <dgm:spPr/>
    </dgm:pt>
    <dgm:pt modelId="{4D51CD01-4087-4EB4-B537-3C2855B0DF76}" type="pres">
      <dgm:prSet presAssocID="{E3228412-3359-44F6-BEC4-5F99FCC39DBF}" presName="Name8" presStyleCnt="0"/>
      <dgm:spPr/>
    </dgm:pt>
    <dgm:pt modelId="{524EF177-FADA-48C0-9941-D1C2B2654016}" type="pres">
      <dgm:prSet presAssocID="{E3228412-3359-44F6-BEC4-5F99FCC39DBF}" presName="level" presStyleLbl="node1" presStyleIdx="6" presStyleCnt="8">
        <dgm:presLayoutVars>
          <dgm:chMax val="1"/>
          <dgm:bulletEnabled val="1"/>
        </dgm:presLayoutVars>
      </dgm:prSet>
      <dgm:spPr/>
    </dgm:pt>
    <dgm:pt modelId="{115DB16F-0E1E-412B-89A7-F8142CAD16E0}" type="pres">
      <dgm:prSet presAssocID="{E3228412-3359-44F6-BEC4-5F99FCC39DBF}" presName="levelTx" presStyleLbl="revTx" presStyleIdx="0" presStyleCnt="0">
        <dgm:presLayoutVars>
          <dgm:chMax val="1"/>
          <dgm:bulletEnabled val="1"/>
        </dgm:presLayoutVars>
      </dgm:prSet>
      <dgm:spPr/>
    </dgm:pt>
    <dgm:pt modelId="{58D06A5E-134D-499A-AC16-9825A6869EC9}" type="pres">
      <dgm:prSet presAssocID="{3D3038A7-59CF-4596-AA4F-38B12853EC5D}" presName="Name8" presStyleCnt="0"/>
      <dgm:spPr/>
    </dgm:pt>
    <dgm:pt modelId="{01FE0B52-38AB-4861-B3B6-56C0419CF3CF}" type="pres">
      <dgm:prSet presAssocID="{3D3038A7-59CF-4596-AA4F-38B12853EC5D}" presName="level" presStyleLbl="node1" presStyleIdx="7" presStyleCnt="8">
        <dgm:presLayoutVars>
          <dgm:chMax val="1"/>
          <dgm:bulletEnabled val="1"/>
        </dgm:presLayoutVars>
      </dgm:prSet>
      <dgm:spPr/>
    </dgm:pt>
    <dgm:pt modelId="{28C8F66D-8CA2-4869-99F5-311BDEB9A482}" type="pres">
      <dgm:prSet presAssocID="{3D3038A7-59CF-4596-AA4F-38B12853EC5D}" presName="levelTx" presStyleLbl="revTx" presStyleIdx="0" presStyleCnt="0">
        <dgm:presLayoutVars>
          <dgm:chMax val="1"/>
          <dgm:bulletEnabled val="1"/>
        </dgm:presLayoutVars>
      </dgm:prSet>
      <dgm:spPr/>
    </dgm:pt>
  </dgm:ptLst>
  <dgm:cxnLst>
    <dgm:cxn modelId="{305D6205-033A-4AAC-9089-878D6ACC4551}" type="presOf" srcId="{B29F69BE-E11B-4DCF-B9F2-CBB9F0B6B047}" destId="{95AC4F6E-E2A0-4BD3-92BD-5152E4140CCF}" srcOrd="0" destOrd="0" presId="urn:microsoft.com/office/officeart/2005/8/layout/pyramid1"/>
    <dgm:cxn modelId="{E38DED1D-9CCB-4207-B132-4D06302B32B4}" type="presOf" srcId="{23A81959-9DAF-4A66-A931-434B4D68B2CE}" destId="{52F230A4-46F3-4C56-AB1E-AC9A318F0B1D}" srcOrd="0" destOrd="0" presId="urn:microsoft.com/office/officeart/2005/8/layout/pyramid1"/>
    <dgm:cxn modelId="{78487635-84BC-4854-A0E7-745C55B6AB6B}" type="presOf" srcId="{2CD770A5-8CCE-473E-8759-5710AD59A9C5}" destId="{A288E0E0-72EA-4844-ADBD-17BB8359F24D}" srcOrd="1" destOrd="0" presId="urn:microsoft.com/office/officeart/2005/8/layout/pyramid1"/>
    <dgm:cxn modelId="{CFA34839-013E-426B-BE52-C7D4E685DA9C}" type="presOf" srcId="{E3228412-3359-44F6-BEC4-5F99FCC39DBF}" destId="{524EF177-FADA-48C0-9941-D1C2B2654016}" srcOrd="0" destOrd="0" presId="urn:microsoft.com/office/officeart/2005/8/layout/pyramid1"/>
    <dgm:cxn modelId="{C21E103A-C588-4DD3-A505-D53BBFE1F270}" srcId="{E762C252-98A1-497D-919F-DAFDEC46D2B2}" destId="{5EA83D5F-1F4E-4B08-82CE-EEEABE7EC1C6}" srcOrd="1" destOrd="0" parTransId="{84861E9C-09B2-4603-A93E-DAF0D4B67CBD}" sibTransId="{21B4D78D-C15A-4847-A09A-B0B7FA3E12F1}"/>
    <dgm:cxn modelId="{6975433B-3C4A-4582-9F5A-EEB42F8D2A14}" type="presOf" srcId="{5EA83D5F-1F4E-4B08-82CE-EEEABE7EC1C6}" destId="{366F6834-4A90-4A1C-9593-CDA1B22061F7}" srcOrd="0" destOrd="0" presId="urn:microsoft.com/office/officeart/2005/8/layout/pyramid1"/>
    <dgm:cxn modelId="{F163E73D-7D31-4853-B74F-75C876908B2F}" srcId="{E762C252-98A1-497D-919F-DAFDEC46D2B2}" destId="{3D3038A7-59CF-4596-AA4F-38B12853EC5D}" srcOrd="7" destOrd="0" parTransId="{679D0C2D-D02C-4C7B-A9C6-94A7BEA121DF}" sibTransId="{A5F62FDE-6607-49C8-96BD-4CC04BFF909B}"/>
    <dgm:cxn modelId="{90F3A262-0146-4727-90C5-AB0A3FFF39F7}" type="presOf" srcId="{F96D4AB5-27E5-449A-A474-0E563B8323CC}" destId="{8A1F90FE-AA88-4709-AA45-907D19FFAD34}" srcOrd="0" destOrd="0" presId="urn:microsoft.com/office/officeart/2005/8/layout/pyramid1"/>
    <dgm:cxn modelId="{05420B6B-AE01-460D-9484-D153B3449A55}" type="presOf" srcId="{ECC94DE3-A5F2-4819-A353-9B3C810F44B6}" destId="{51637772-85AE-4A8B-B982-A9E30FB56790}" srcOrd="1" destOrd="0" presId="urn:microsoft.com/office/officeart/2005/8/layout/pyramid1"/>
    <dgm:cxn modelId="{6FE33B6B-3290-4C92-A4BE-1051CEB9C6C8}" type="presOf" srcId="{3D3038A7-59CF-4596-AA4F-38B12853EC5D}" destId="{28C8F66D-8CA2-4869-99F5-311BDEB9A482}" srcOrd="1" destOrd="0" presId="urn:microsoft.com/office/officeart/2005/8/layout/pyramid1"/>
    <dgm:cxn modelId="{726A6979-6BDD-4927-9D94-9CBCF8FB3472}" type="presOf" srcId="{3D3038A7-59CF-4596-AA4F-38B12853EC5D}" destId="{01FE0B52-38AB-4861-B3B6-56C0419CF3CF}" srcOrd="0" destOrd="0" presId="urn:microsoft.com/office/officeart/2005/8/layout/pyramid1"/>
    <dgm:cxn modelId="{30A4298A-27F6-4490-89A8-952903301D8D}" type="presOf" srcId="{ECC94DE3-A5F2-4819-A353-9B3C810F44B6}" destId="{BF6D9866-EBC3-4B0B-9CF5-B105A23975E6}" srcOrd="0" destOrd="0" presId="urn:microsoft.com/office/officeart/2005/8/layout/pyramid1"/>
    <dgm:cxn modelId="{E8C58D8B-DC9C-4D0B-AFC1-2DD31C7B6859}" srcId="{E762C252-98A1-497D-919F-DAFDEC46D2B2}" destId="{B29F69BE-E11B-4DCF-B9F2-CBB9F0B6B047}" srcOrd="4" destOrd="0" parTransId="{54FC7A0A-61D1-423D-9EBC-574BDB3D5B3A}" sibTransId="{3FCFF8DF-7049-41B4-9A01-D493F95FA7A8}"/>
    <dgm:cxn modelId="{9097D68F-5EBB-4D3C-8B8C-82D244C59AA9}" type="presOf" srcId="{F96D4AB5-27E5-449A-A474-0E563B8323CC}" destId="{AD11D3CE-56F9-4089-ADFB-B29A70C9749E}" srcOrd="1" destOrd="0" presId="urn:microsoft.com/office/officeart/2005/8/layout/pyramid1"/>
    <dgm:cxn modelId="{853AD1A7-A969-4595-BACE-CB723B366822}" srcId="{E762C252-98A1-497D-919F-DAFDEC46D2B2}" destId="{ECC94DE3-A5F2-4819-A353-9B3C810F44B6}" srcOrd="3" destOrd="0" parTransId="{DE7D661A-63E1-438F-993D-AF092FE57F04}" sibTransId="{E1014FED-BD02-4827-B92D-CAF0C2EFC5B6}"/>
    <dgm:cxn modelId="{BDF884B3-04A3-4E21-BB7C-64D3E4871D48}" type="presOf" srcId="{B29F69BE-E11B-4DCF-B9F2-CBB9F0B6B047}" destId="{32EA77F0-298B-416A-96F0-D96662EED690}" srcOrd="1" destOrd="0" presId="urn:microsoft.com/office/officeart/2005/8/layout/pyramid1"/>
    <dgm:cxn modelId="{62D0A2B9-8241-4BFC-8129-975119A3BA8E}" srcId="{E762C252-98A1-497D-919F-DAFDEC46D2B2}" destId="{E3228412-3359-44F6-BEC4-5F99FCC39DBF}" srcOrd="6" destOrd="0" parTransId="{C801C87D-9711-47CD-972D-F1F17680A1AF}" sibTransId="{5DAC7549-C2AD-4C07-AA12-F302339C5DBA}"/>
    <dgm:cxn modelId="{AF9C41C0-D52D-492C-A9F3-83D86D24565F}" srcId="{E762C252-98A1-497D-919F-DAFDEC46D2B2}" destId="{F96D4AB5-27E5-449A-A474-0E563B8323CC}" srcOrd="5" destOrd="0" parTransId="{9575EC6D-41E4-41BE-9C9A-E2E2E1A930B9}" sibTransId="{98E66F92-DC86-46A3-B44B-DA1E6656B40F}"/>
    <dgm:cxn modelId="{C94B77C5-E49C-443A-959E-33EBEF4A0D27}" type="presOf" srcId="{2CD770A5-8CCE-473E-8759-5710AD59A9C5}" destId="{D8056657-2F28-450B-B42C-D134123F4288}" srcOrd="0" destOrd="0" presId="urn:microsoft.com/office/officeart/2005/8/layout/pyramid1"/>
    <dgm:cxn modelId="{270739DC-03B5-474B-BF4F-75A3801CBB4C}" type="presOf" srcId="{E3228412-3359-44F6-BEC4-5F99FCC39DBF}" destId="{115DB16F-0E1E-412B-89A7-F8142CAD16E0}" srcOrd="1" destOrd="0" presId="urn:microsoft.com/office/officeart/2005/8/layout/pyramid1"/>
    <dgm:cxn modelId="{C8CA9DDF-2620-43A7-A7B3-D16A532A39EB}" type="presOf" srcId="{23A81959-9DAF-4A66-A931-434B4D68B2CE}" destId="{1E4848D2-13D5-4416-B98A-EE648758EE7C}" srcOrd="1" destOrd="0" presId="urn:microsoft.com/office/officeart/2005/8/layout/pyramid1"/>
    <dgm:cxn modelId="{BA50EBE4-608C-485F-AD24-6630C8A7DBCB}" type="presOf" srcId="{E762C252-98A1-497D-919F-DAFDEC46D2B2}" destId="{D4A27A54-F805-4733-ACFD-480773DFFFC3}" srcOrd="0" destOrd="0" presId="urn:microsoft.com/office/officeart/2005/8/layout/pyramid1"/>
    <dgm:cxn modelId="{FE61D5E6-AB9D-42ED-B315-99F3F86659B2}" srcId="{E762C252-98A1-497D-919F-DAFDEC46D2B2}" destId="{2CD770A5-8CCE-473E-8759-5710AD59A9C5}" srcOrd="0" destOrd="0" parTransId="{C75148B3-5216-401C-909A-97448EBE5BE9}" sibTransId="{5941C607-6913-4866-9BED-8CE364745D66}"/>
    <dgm:cxn modelId="{ED0471F2-0366-4079-8661-2BCBD17A36B6}" srcId="{E762C252-98A1-497D-919F-DAFDEC46D2B2}" destId="{23A81959-9DAF-4A66-A931-434B4D68B2CE}" srcOrd="2" destOrd="0" parTransId="{6CBB977C-4393-4220-B6F8-13EF0EE740C8}" sibTransId="{4090513E-EBF8-40A2-A921-F896A0836985}"/>
    <dgm:cxn modelId="{EC350EFE-97DF-4A1D-86B4-449CAD1358A3}" type="presOf" srcId="{5EA83D5F-1F4E-4B08-82CE-EEEABE7EC1C6}" destId="{91C49125-F316-4C05-9F0A-0DEC7F770452}" srcOrd="1" destOrd="0" presId="urn:microsoft.com/office/officeart/2005/8/layout/pyramid1"/>
    <dgm:cxn modelId="{C6B05B5F-B204-4869-A7EA-8BE172146ABC}" type="presParOf" srcId="{D4A27A54-F805-4733-ACFD-480773DFFFC3}" destId="{3EB60814-3901-490A-8A12-82C6AC32D15E}" srcOrd="0" destOrd="0" presId="urn:microsoft.com/office/officeart/2005/8/layout/pyramid1"/>
    <dgm:cxn modelId="{F993F2BB-148B-485E-B77A-A95E24BCA4EF}" type="presParOf" srcId="{3EB60814-3901-490A-8A12-82C6AC32D15E}" destId="{D8056657-2F28-450B-B42C-D134123F4288}" srcOrd="0" destOrd="0" presId="urn:microsoft.com/office/officeart/2005/8/layout/pyramid1"/>
    <dgm:cxn modelId="{33D706CA-24ED-4AAB-B78C-F725E2B91B03}" type="presParOf" srcId="{3EB60814-3901-490A-8A12-82C6AC32D15E}" destId="{A288E0E0-72EA-4844-ADBD-17BB8359F24D}" srcOrd="1" destOrd="0" presId="urn:microsoft.com/office/officeart/2005/8/layout/pyramid1"/>
    <dgm:cxn modelId="{2AA73DB5-F273-4428-8F91-4B2629B958AA}" type="presParOf" srcId="{D4A27A54-F805-4733-ACFD-480773DFFFC3}" destId="{0323997A-69AE-4D5B-ABA5-1A6D3E0639D5}" srcOrd="1" destOrd="0" presId="urn:microsoft.com/office/officeart/2005/8/layout/pyramid1"/>
    <dgm:cxn modelId="{D872A9C4-7D0E-46EF-9A5B-BB7AFE69CD7A}" type="presParOf" srcId="{0323997A-69AE-4D5B-ABA5-1A6D3E0639D5}" destId="{366F6834-4A90-4A1C-9593-CDA1B22061F7}" srcOrd="0" destOrd="0" presId="urn:microsoft.com/office/officeart/2005/8/layout/pyramid1"/>
    <dgm:cxn modelId="{162631F9-29F4-41A1-B0F1-ED916E7B9625}" type="presParOf" srcId="{0323997A-69AE-4D5B-ABA5-1A6D3E0639D5}" destId="{91C49125-F316-4C05-9F0A-0DEC7F770452}" srcOrd="1" destOrd="0" presId="urn:microsoft.com/office/officeart/2005/8/layout/pyramid1"/>
    <dgm:cxn modelId="{865069A8-BA10-4D16-966A-A3DCAF99CF7D}" type="presParOf" srcId="{D4A27A54-F805-4733-ACFD-480773DFFFC3}" destId="{16D21530-214B-4D60-8F72-9456FC8EEA7E}" srcOrd="2" destOrd="0" presId="urn:microsoft.com/office/officeart/2005/8/layout/pyramid1"/>
    <dgm:cxn modelId="{01AE1DDB-E938-4AE4-A810-F6405C718595}" type="presParOf" srcId="{16D21530-214B-4D60-8F72-9456FC8EEA7E}" destId="{52F230A4-46F3-4C56-AB1E-AC9A318F0B1D}" srcOrd="0" destOrd="0" presId="urn:microsoft.com/office/officeart/2005/8/layout/pyramid1"/>
    <dgm:cxn modelId="{F7D5E710-0BBF-4A03-AA12-48BD5CC2CAE1}" type="presParOf" srcId="{16D21530-214B-4D60-8F72-9456FC8EEA7E}" destId="{1E4848D2-13D5-4416-B98A-EE648758EE7C}" srcOrd="1" destOrd="0" presId="urn:microsoft.com/office/officeart/2005/8/layout/pyramid1"/>
    <dgm:cxn modelId="{413C8B62-AFB9-4895-9CB7-7992086D86DC}" type="presParOf" srcId="{D4A27A54-F805-4733-ACFD-480773DFFFC3}" destId="{43464430-AB15-4C68-B50E-A635B390C6AE}" srcOrd="3" destOrd="0" presId="urn:microsoft.com/office/officeart/2005/8/layout/pyramid1"/>
    <dgm:cxn modelId="{B35BA5C8-A757-4B4A-AB66-F6921AA7DDDE}" type="presParOf" srcId="{43464430-AB15-4C68-B50E-A635B390C6AE}" destId="{BF6D9866-EBC3-4B0B-9CF5-B105A23975E6}" srcOrd="0" destOrd="0" presId="urn:microsoft.com/office/officeart/2005/8/layout/pyramid1"/>
    <dgm:cxn modelId="{D68FF0C5-D1E1-47A3-86FB-4DC9A8D41D49}" type="presParOf" srcId="{43464430-AB15-4C68-B50E-A635B390C6AE}" destId="{51637772-85AE-4A8B-B982-A9E30FB56790}" srcOrd="1" destOrd="0" presId="urn:microsoft.com/office/officeart/2005/8/layout/pyramid1"/>
    <dgm:cxn modelId="{F8FD4BEC-F682-4469-9AB9-6C1D322E8F71}" type="presParOf" srcId="{D4A27A54-F805-4733-ACFD-480773DFFFC3}" destId="{134E3235-B25D-48C7-9DDD-ABB5E1D38E41}" srcOrd="4" destOrd="0" presId="urn:microsoft.com/office/officeart/2005/8/layout/pyramid1"/>
    <dgm:cxn modelId="{3C6597A7-6C77-4AD4-A11B-EEF11440E79B}" type="presParOf" srcId="{134E3235-B25D-48C7-9DDD-ABB5E1D38E41}" destId="{95AC4F6E-E2A0-4BD3-92BD-5152E4140CCF}" srcOrd="0" destOrd="0" presId="urn:microsoft.com/office/officeart/2005/8/layout/pyramid1"/>
    <dgm:cxn modelId="{7775EE8F-EE39-4F8D-A15C-353847053136}" type="presParOf" srcId="{134E3235-B25D-48C7-9DDD-ABB5E1D38E41}" destId="{32EA77F0-298B-416A-96F0-D96662EED690}" srcOrd="1" destOrd="0" presId="urn:microsoft.com/office/officeart/2005/8/layout/pyramid1"/>
    <dgm:cxn modelId="{B5113406-03DB-4159-82CF-64DD8CC05DC9}" type="presParOf" srcId="{D4A27A54-F805-4733-ACFD-480773DFFFC3}" destId="{2CB3E8AB-F903-4A6C-916E-428EEF96FBE4}" srcOrd="5" destOrd="0" presId="urn:microsoft.com/office/officeart/2005/8/layout/pyramid1"/>
    <dgm:cxn modelId="{5BD77741-3EC4-4700-A2E9-F1EA8BA97FD2}" type="presParOf" srcId="{2CB3E8AB-F903-4A6C-916E-428EEF96FBE4}" destId="{8A1F90FE-AA88-4709-AA45-907D19FFAD34}" srcOrd="0" destOrd="0" presId="urn:microsoft.com/office/officeart/2005/8/layout/pyramid1"/>
    <dgm:cxn modelId="{C0732083-6349-4A0E-9ACC-054268FEF8E1}" type="presParOf" srcId="{2CB3E8AB-F903-4A6C-916E-428EEF96FBE4}" destId="{AD11D3CE-56F9-4089-ADFB-B29A70C9749E}" srcOrd="1" destOrd="0" presId="urn:microsoft.com/office/officeart/2005/8/layout/pyramid1"/>
    <dgm:cxn modelId="{769DEC5C-F864-484E-8630-A7CB578CB25C}" type="presParOf" srcId="{D4A27A54-F805-4733-ACFD-480773DFFFC3}" destId="{4D51CD01-4087-4EB4-B537-3C2855B0DF76}" srcOrd="6" destOrd="0" presId="urn:microsoft.com/office/officeart/2005/8/layout/pyramid1"/>
    <dgm:cxn modelId="{494AACB2-CDFB-4A52-8AED-50719BA97F4A}" type="presParOf" srcId="{4D51CD01-4087-4EB4-B537-3C2855B0DF76}" destId="{524EF177-FADA-48C0-9941-D1C2B2654016}" srcOrd="0" destOrd="0" presId="urn:microsoft.com/office/officeart/2005/8/layout/pyramid1"/>
    <dgm:cxn modelId="{AF7787A9-3E2F-4BD4-A669-20BFEFAE8039}" type="presParOf" srcId="{4D51CD01-4087-4EB4-B537-3C2855B0DF76}" destId="{115DB16F-0E1E-412B-89A7-F8142CAD16E0}" srcOrd="1" destOrd="0" presId="urn:microsoft.com/office/officeart/2005/8/layout/pyramid1"/>
    <dgm:cxn modelId="{8D95DC6B-FE3C-42F8-8CF7-3D71B1260F11}" type="presParOf" srcId="{D4A27A54-F805-4733-ACFD-480773DFFFC3}" destId="{58D06A5E-134D-499A-AC16-9825A6869EC9}" srcOrd="7" destOrd="0" presId="urn:microsoft.com/office/officeart/2005/8/layout/pyramid1"/>
    <dgm:cxn modelId="{E48EB928-DD02-4393-97F7-47D3C2F1A718}" type="presParOf" srcId="{58D06A5E-134D-499A-AC16-9825A6869EC9}" destId="{01FE0B52-38AB-4861-B3B6-56C0419CF3CF}" srcOrd="0" destOrd="0" presId="urn:microsoft.com/office/officeart/2005/8/layout/pyramid1"/>
    <dgm:cxn modelId="{6E701692-BE95-4824-BB21-BA908C915231}" type="presParOf" srcId="{58D06A5E-134D-499A-AC16-9825A6869EC9}" destId="{28C8F66D-8CA2-4869-99F5-311BDEB9A482}" srcOrd="1" destOrd="0" presId="urn:microsoft.com/office/officeart/2005/8/layout/pyramid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D8056657-2F28-450B-B42C-D134123F4288}">
      <dsp:nvSpPr>
        <dsp:cNvPr id="0" name=""/>
        <dsp:cNvSpPr/>
      </dsp:nvSpPr>
      <dsp:spPr>
        <a:xfrm>
          <a:off x="2968284" y="0"/>
          <a:ext cx="1534548" cy="838568"/>
        </a:xfrm>
        <a:prstGeom prst="trapezoid">
          <a:avLst>
            <a:gd name="adj" fmla="val 83266"/>
          </a:avLst>
        </a:prstGeom>
        <a:solidFill>
          <a:schemeClr val="accent5">
            <a:shade val="80000"/>
            <a:hueOff val="0"/>
            <a:satOff val="0"/>
            <a:lumOff val="0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7780" tIns="17780" rIns="1778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ar-SY" sz="1400" b="1" kern="1200" dirty="0"/>
            <a:t>التجارب السريرية العشوائية ذات الشواهد</a:t>
          </a:r>
          <a:endParaRPr lang="en-US" sz="1400" b="1" kern="1200" dirty="0"/>
        </a:p>
      </dsp:txBody>
      <dsp:txXfrm>
        <a:off x="2968284" y="0"/>
        <a:ext cx="1534548" cy="838568"/>
      </dsp:txXfrm>
    </dsp:sp>
    <dsp:sp modelId="{366F6834-4A90-4A1C-9593-CDA1B22061F7}">
      <dsp:nvSpPr>
        <dsp:cNvPr id="0" name=""/>
        <dsp:cNvSpPr/>
      </dsp:nvSpPr>
      <dsp:spPr>
        <a:xfrm>
          <a:off x="2718796" y="838568"/>
          <a:ext cx="2033523" cy="382526"/>
        </a:xfrm>
        <a:prstGeom prst="trapezoid">
          <a:avLst>
            <a:gd name="adj" fmla="val 83266"/>
          </a:avLst>
        </a:prstGeom>
        <a:solidFill>
          <a:schemeClr val="accent5">
            <a:shade val="80000"/>
            <a:hueOff val="49898"/>
            <a:satOff val="-894"/>
            <a:lumOff val="3798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7780" tIns="17780" rIns="1778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ar-SY" sz="1400" b="1" kern="1200"/>
            <a:t>الدراسات</a:t>
          </a:r>
          <a:r>
            <a:rPr lang="ar-SY" sz="1200" b="1" kern="1200"/>
            <a:t> </a:t>
          </a:r>
          <a:r>
            <a:rPr lang="ar-SY" sz="1400" b="1" kern="1200"/>
            <a:t>الحشدية</a:t>
          </a:r>
          <a:endParaRPr lang="en-US" sz="1200" b="1" kern="1200"/>
        </a:p>
      </dsp:txBody>
      <dsp:txXfrm>
        <a:off x="3074663" y="838568"/>
        <a:ext cx="1321790" cy="382526"/>
      </dsp:txXfrm>
    </dsp:sp>
    <dsp:sp modelId="{52F230A4-46F3-4C56-AB1E-AC9A318F0B1D}">
      <dsp:nvSpPr>
        <dsp:cNvPr id="0" name=""/>
        <dsp:cNvSpPr/>
      </dsp:nvSpPr>
      <dsp:spPr>
        <a:xfrm>
          <a:off x="2265663" y="1221095"/>
          <a:ext cx="2939789" cy="544196"/>
        </a:xfrm>
        <a:prstGeom prst="trapezoid">
          <a:avLst>
            <a:gd name="adj" fmla="val 83266"/>
          </a:avLst>
        </a:prstGeom>
        <a:solidFill>
          <a:schemeClr val="accent5">
            <a:shade val="80000"/>
            <a:hueOff val="99795"/>
            <a:satOff val="-1787"/>
            <a:lumOff val="7596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7780" tIns="17780" rIns="1778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ar-SY" sz="1400" b="1" kern="1200" dirty="0"/>
            <a:t>دراسة مراقبة الحالات والشواهد</a:t>
          </a:r>
          <a:endParaRPr lang="en-US" sz="1400" b="1" kern="1200" dirty="0"/>
        </a:p>
      </dsp:txBody>
      <dsp:txXfrm>
        <a:off x="2780126" y="1221095"/>
        <a:ext cx="1910863" cy="544196"/>
      </dsp:txXfrm>
    </dsp:sp>
    <dsp:sp modelId="{BF6D9866-EBC3-4B0B-9CF5-B105A23975E6}">
      <dsp:nvSpPr>
        <dsp:cNvPr id="0" name=""/>
        <dsp:cNvSpPr/>
      </dsp:nvSpPr>
      <dsp:spPr>
        <a:xfrm>
          <a:off x="1812531" y="1765291"/>
          <a:ext cx="3846054" cy="544196"/>
        </a:xfrm>
        <a:prstGeom prst="trapezoid">
          <a:avLst>
            <a:gd name="adj" fmla="val 83266"/>
          </a:avLst>
        </a:prstGeom>
        <a:solidFill>
          <a:schemeClr val="accent5">
            <a:shade val="80000"/>
            <a:hueOff val="149693"/>
            <a:satOff val="-2681"/>
            <a:lumOff val="11394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7780" tIns="17780" rIns="1778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ar-SY" sz="1400" b="1" kern="1200" dirty="0"/>
            <a:t>تقارير حالات</a:t>
          </a:r>
          <a:endParaRPr lang="en-US" sz="1400" b="1" kern="1200" dirty="0"/>
        </a:p>
      </dsp:txBody>
      <dsp:txXfrm>
        <a:off x="2485590" y="1765291"/>
        <a:ext cx="2499935" cy="544196"/>
      </dsp:txXfrm>
    </dsp:sp>
    <dsp:sp modelId="{95AC4F6E-E2A0-4BD3-92BD-5152E4140CCF}">
      <dsp:nvSpPr>
        <dsp:cNvPr id="0" name=""/>
        <dsp:cNvSpPr/>
      </dsp:nvSpPr>
      <dsp:spPr>
        <a:xfrm>
          <a:off x="1359398" y="2309488"/>
          <a:ext cx="4752320" cy="544196"/>
        </a:xfrm>
        <a:prstGeom prst="trapezoid">
          <a:avLst>
            <a:gd name="adj" fmla="val 83266"/>
          </a:avLst>
        </a:prstGeom>
        <a:solidFill>
          <a:schemeClr val="accent5">
            <a:shade val="80000"/>
            <a:hueOff val="199590"/>
            <a:satOff val="-3575"/>
            <a:lumOff val="15191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7780" tIns="17780" rIns="1778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ar-SY" sz="1400" b="1" kern="1200"/>
            <a:t>تقرير حالة</a:t>
          </a:r>
          <a:endParaRPr lang="en-US" sz="1400" b="1" kern="1200"/>
        </a:p>
      </dsp:txBody>
      <dsp:txXfrm>
        <a:off x="2191054" y="2309488"/>
        <a:ext cx="3089008" cy="544196"/>
      </dsp:txXfrm>
    </dsp:sp>
    <dsp:sp modelId="{8A1F90FE-AA88-4709-AA45-907D19FFAD34}">
      <dsp:nvSpPr>
        <dsp:cNvPr id="0" name=""/>
        <dsp:cNvSpPr/>
      </dsp:nvSpPr>
      <dsp:spPr>
        <a:xfrm>
          <a:off x="906265" y="2853684"/>
          <a:ext cx="5658585" cy="544196"/>
        </a:xfrm>
        <a:prstGeom prst="trapezoid">
          <a:avLst>
            <a:gd name="adj" fmla="val 83266"/>
          </a:avLst>
        </a:prstGeom>
        <a:solidFill>
          <a:schemeClr val="accent5">
            <a:shade val="80000"/>
            <a:hueOff val="249488"/>
            <a:satOff val="-4469"/>
            <a:lumOff val="18989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7780" tIns="17780" rIns="1778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ar-SY" sz="1400" b="1" kern="1200"/>
            <a:t>الدراسات على الحيوانات</a:t>
          </a:r>
          <a:endParaRPr lang="en-US" sz="1400" b="1" kern="1200"/>
        </a:p>
      </dsp:txBody>
      <dsp:txXfrm>
        <a:off x="1896518" y="2853684"/>
        <a:ext cx="3678080" cy="544196"/>
      </dsp:txXfrm>
    </dsp:sp>
    <dsp:sp modelId="{524EF177-FADA-48C0-9941-D1C2B2654016}">
      <dsp:nvSpPr>
        <dsp:cNvPr id="0" name=""/>
        <dsp:cNvSpPr/>
      </dsp:nvSpPr>
      <dsp:spPr>
        <a:xfrm>
          <a:off x="453132" y="3397881"/>
          <a:ext cx="6564851" cy="544196"/>
        </a:xfrm>
        <a:prstGeom prst="trapezoid">
          <a:avLst>
            <a:gd name="adj" fmla="val 83266"/>
          </a:avLst>
        </a:prstGeom>
        <a:solidFill>
          <a:schemeClr val="accent5">
            <a:shade val="80000"/>
            <a:hueOff val="299385"/>
            <a:satOff val="-5362"/>
            <a:lumOff val="22787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7780" tIns="17780" rIns="1778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ar-SY" sz="1400" b="1" kern="1200"/>
            <a:t>الدراسات في المخبر</a:t>
          </a:r>
          <a:endParaRPr lang="en-US" sz="1400" b="1" kern="1200"/>
        </a:p>
      </dsp:txBody>
      <dsp:txXfrm>
        <a:off x="1601981" y="3397881"/>
        <a:ext cx="4267153" cy="544196"/>
      </dsp:txXfrm>
    </dsp:sp>
    <dsp:sp modelId="{01FE0B52-38AB-4861-B3B6-56C0419CF3CF}">
      <dsp:nvSpPr>
        <dsp:cNvPr id="0" name=""/>
        <dsp:cNvSpPr/>
      </dsp:nvSpPr>
      <dsp:spPr>
        <a:xfrm>
          <a:off x="0" y="3942077"/>
          <a:ext cx="7471117" cy="544196"/>
        </a:xfrm>
        <a:prstGeom prst="trapezoid">
          <a:avLst>
            <a:gd name="adj" fmla="val 83266"/>
          </a:avLst>
        </a:prstGeom>
        <a:solidFill>
          <a:schemeClr val="accent5">
            <a:shade val="80000"/>
            <a:hueOff val="349283"/>
            <a:satOff val="-6256"/>
            <a:lumOff val="26585"/>
            <a:alphaOff val="0"/>
          </a:schemeClr>
        </a:solidFill>
        <a:ln w="1905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17780" tIns="17780" rIns="17780" bIns="1778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ar-SY" sz="1400" b="1" kern="1200" dirty="0"/>
            <a:t>رأي الخبراء</a:t>
          </a:r>
          <a:endParaRPr lang="en-US" sz="1400" b="1" kern="1200" dirty="0"/>
        </a:p>
      </dsp:txBody>
      <dsp:txXfrm>
        <a:off x="1307445" y="3942077"/>
        <a:ext cx="4856226" cy="544196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yramid1">
  <dgm:title val=""/>
  <dgm:desc val=""/>
  <dgm:catLst>
    <dgm:cat type="pyramid" pri="1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animLvl val="lvl"/>
      <dgm:resizeHandles val="exact"/>
    </dgm:varLst>
    <dgm:choose name="Name1">
      <dgm:if name="Name2" func="var" arg="dir" op="equ" val="norm">
        <dgm:alg type="pyra">
          <dgm:param type="linDir" val="fromB"/>
          <dgm:param type="txDir" val="fromT"/>
          <dgm:param type="pyraAcctPos" val="aft"/>
          <dgm:param type="pyraAcctTxMar" val="step"/>
          <dgm:param type="pyraAcctBkgdNode" val="acctBkgd"/>
          <dgm:param type="pyraAcctTxNode" val="acctTx"/>
          <dgm:param type="pyraLvlNode" val="level"/>
        </dgm:alg>
      </dgm:if>
      <dgm:else name="Name3">
        <dgm:alg type="pyra">
          <dgm:param type="linDir" val="fromB"/>
          <dgm:param type="txDir" val="fromT"/>
          <dgm:param type="pyraAcctPos" val="bef"/>
          <dgm:param type="pyraAcctTxMar" val="step"/>
          <dgm:param type="pyraAcctBkgdNode" val="acctBkgd"/>
          <dgm:param type="pyraAcctTxNode" val="acctTx"/>
          <dgm:param type="pyraLvlNode" val="level"/>
        </dgm:alg>
      </dgm:else>
    </dgm:choose>
    <dgm:shape xmlns:r="http://schemas.openxmlformats.org/officeDocument/2006/relationships" r:blip="">
      <dgm:adjLst/>
    </dgm:shape>
    <dgm:presOf/>
    <dgm:choose name="Name4">
      <dgm:if name="Name5" axis="root des" ptType="all node" func="maxDepth" op="gte" val="2">
        <dgm:constrLst>
          <dgm:constr type="primFontSz" for="des" forName="levelTx" op="equ"/>
          <dgm:constr type="secFontSz" for="des" forName="acctTx" op="equ"/>
          <dgm:constr type="pyraAcctRatio" val="0.32"/>
        </dgm:constrLst>
      </dgm:if>
      <dgm:else name="Name6">
        <dgm:constrLst>
          <dgm:constr type="primFontSz" for="des" forName="levelTx" op="equ"/>
          <dgm:constr type="secFontSz" for="des" forName="acctTx" op="equ"/>
          <dgm:constr type="pyraAcctRatio"/>
        </dgm:constrLst>
      </dgm:else>
    </dgm:choose>
    <dgm:ruleLst/>
    <dgm:forEach name="Name7" axis="ch" ptType="node">
      <dgm:layoutNode name="Name8">
        <dgm:alg type="composite">
          <dgm:param type="horzAlign" val="none"/>
        </dgm:alg>
        <dgm:shape xmlns:r="http://schemas.openxmlformats.org/officeDocument/2006/relationships" r:blip="">
          <dgm:adjLst/>
        </dgm:shape>
        <dgm:presOf/>
        <dgm:choose name="Name9">
          <dgm:if name="Name10" axis="self" ptType="node" func="pos" op="equ" val="1">
            <dgm:constrLst>
              <dgm:constr type="ctrX" for="ch" forName="acctBkgd" val="1"/>
              <dgm:constr type="ctrY" for="ch" forName="acctBkgd" val="1"/>
              <dgm:constr type="w" for="ch" forName="acctBkgd" val="1"/>
              <dgm:constr type="h" for="ch" forName="acctBkgd" val="1"/>
              <dgm:constr type="ctrX" for="ch" forName="acctTx" val="1"/>
              <dgm:constr type="ctrY" for="ch" forName="acctTx" val="1"/>
              <dgm:constr type="w" for="ch" forName="acctTx" val="1"/>
              <dgm:constr type="h" for="ch" forName="acctTx" val="1"/>
              <dgm:constr type="ctrX" for="ch" forName="level" val="1"/>
              <dgm:constr type="ctrY" for="ch" forName="level" val="1"/>
              <dgm:constr type="w" for="ch" forName="level" val="1"/>
              <dgm:constr type="h" for="ch" forName="level" val="1"/>
              <dgm:constr type="ctrX" for="ch" forName="levelTx" refType="ctrX" refFor="ch" refForName="level"/>
              <dgm:constr type="ctrY" for="ch" forName="levelTx" refType="ctrY" refFor="ch" refForName="level"/>
              <dgm:constr type="w" for="ch" forName="levelTx" refType="w" refFor="ch" refForName="level"/>
              <dgm:constr type="h" for="ch" forName="levelTx" refType="h" refFor="ch" refForName="level"/>
            </dgm:constrLst>
          </dgm:if>
          <dgm:else name="Name11">
            <dgm:constrLst>
              <dgm:constr type="ctrX" for="ch" forName="acctBkgd" val="1"/>
              <dgm:constr type="ctrY" for="ch" forName="acctBkgd" val="1"/>
              <dgm:constr type="w" for="ch" forName="acctBkgd" val="1"/>
              <dgm:constr type="h" for="ch" forName="acctBkgd" val="1"/>
              <dgm:constr type="ctrX" for="ch" forName="acctTx" val="1"/>
              <dgm:constr type="ctrY" for="ch" forName="acctTx" val="1"/>
              <dgm:constr type="w" for="ch" forName="acctTx" val="1"/>
              <dgm:constr type="h" for="ch" forName="acctTx" val="1"/>
              <dgm:constr type="ctrX" for="ch" forName="level" val="1"/>
              <dgm:constr type="ctrY" for="ch" forName="level" val="1"/>
              <dgm:constr type="w" for="ch" forName="level" val="1"/>
              <dgm:constr type="h" for="ch" forName="level" val="1"/>
              <dgm:constr type="ctrX" for="ch" forName="levelTx" refType="ctrX" refFor="ch" refForName="level"/>
              <dgm:constr type="ctrY" for="ch" forName="levelTx" refType="ctrY" refFor="ch" refForName="level"/>
              <dgm:constr type="w" for="ch" forName="levelTx" refType="w" refFor="ch" refForName="level" fact="0.65"/>
              <dgm:constr type="h" for="ch" forName="levelTx" refType="h" refFor="ch" refForName="level"/>
            </dgm:constrLst>
          </dgm:else>
        </dgm:choose>
        <dgm:ruleLst/>
        <dgm:choose name="Name12">
          <dgm:if name="Name13" axis="ch" ptType="node" func="cnt" op="gte" val="1">
            <dgm:layoutNode name="acctBkgd" styleLbl="alignAcc1">
              <dgm:alg type="sp"/>
              <dgm:shape xmlns:r="http://schemas.openxmlformats.org/officeDocument/2006/relationships" type="nonIsoscelesTrapezoid" r:blip="">
                <dgm:adjLst/>
              </dgm:shape>
              <dgm:presOf axis="des" ptType="node"/>
              <dgm:constrLst/>
              <dgm:ruleLst/>
            </dgm:layoutNode>
            <dgm:layoutNode name="acctTx" styleLbl="alignAcc1">
              <dgm:varLst>
                <dgm:bulletEnabled val="1"/>
              </dgm:varLst>
              <dgm:alg type="tx">
                <dgm:param type="stBulletLvl" val="1"/>
                <dgm:param type="txAnchorVertCh" val="mid"/>
              </dgm:alg>
              <dgm:shape xmlns:r="http://schemas.openxmlformats.org/officeDocument/2006/relationships" type="nonIsoscelesTrapezoid" r:blip="" hideGeom="1">
                <dgm:adjLst/>
              </dgm:shape>
              <dgm:presOf axis="des" ptType="node"/>
              <dgm:constrLst>
                <dgm:constr type="secFontSz" val="65"/>
                <dgm:constr type="primFontSz" refType="secFontSz"/>
                <dgm:constr type="tMarg" refType="secFontSz" fact="0.3"/>
                <dgm:constr type="bMarg" refType="secFontSz" fact="0.3"/>
                <dgm:constr type="lMarg" refType="secFontSz" fact="0.3"/>
                <dgm:constr type="rMarg" refType="secFontSz" fact="0.3"/>
              </dgm:constrLst>
              <dgm:ruleLst>
                <dgm:rule type="secFontSz" val="5" fact="NaN" max="NaN"/>
              </dgm:ruleLst>
            </dgm:layoutNode>
          </dgm:if>
          <dgm:else name="Name14"/>
        </dgm:choose>
        <dgm:layoutNode name="level">
          <dgm:varLst>
            <dgm:chMax val="1"/>
            <dgm:bulletEnabled val="1"/>
          </dgm:varLst>
          <dgm:alg type="sp"/>
          <dgm:shape xmlns:r="http://schemas.openxmlformats.org/officeDocument/2006/relationships" type="trapezoid" r:blip="">
            <dgm:adjLst/>
          </dgm:shape>
          <dgm:presOf axis="self"/>
          <dgm:constrLst>
            <dgm:constr type="h" val="500"/>
            <dgm:constr type="w" val="1"/>
          </dgm:constrLst>
          <dgm:ruleLst/>
        </dgm:layoutNode>
        <dgm:layoutNode name="levelTx" styleLbl="revTx">
          <dgm:varLst>
            <dgm:chMax val="1"/>
            <dgm:bulletEnabled val="1"/>
          </dgm:varLst>
          <dgm:alg type="tx"/>
          <dgm:shape xmlns:r="http://schemas.openxmlformats.org/officeDocument/2006/relationships" type="rect" r:blip="" hideGeom="1">
            <dgm:adjLst/>
          </dgm:shape>
          <dgm:presOf axis="self"/>
          <dgm:constrLst>
            <dgm:constr type="tMarg" refType="primFontSz" fact="0.1"/>
            <dgm:constr type="bMarg" refType="primFontSz" fact="0.1"/>
            <dgm:constr type="lMarg" refType="primFontSz" fact="0.1"/>
            <dgm:constr type="rMarg" refType="primFontSz" fact="0.1"/>
            <dgm:constr type="primFontSz" val="65"/>
          </dgm:constrLst>
          <dgm:ruleLst>
            <dgm:rule type="primFontSz" val="5" fact="NaN" max="NaN"/>
          </dgm:ruleLst>
        </dgm:layoutNode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2">
  <dgm:title val=""/>
  <dgm:desc val=""/>
  <dgm:catLst>
    <dgm:cat type="simple" pri="102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9027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09744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3085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8717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596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5122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116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8000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783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31233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48B0EF-3C06-4365-85ED-831195B7F133}" type="datetimeFigureOut">
              <a:rPr lang="en-US" smtClean="0"/>
              <a:t>6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9572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48B0EF-3C06-4365-85ED-831195B7F133}" type="datetimeFigureOut">
              <a:rPr lang="en-US" smtClean="0"/>
              <a:t>6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99071C-8DAA-4900-8A94-A4AF266EE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0036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fi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fi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hyperlink" Target="https://doi.org/10.1016/S0140-6736(16)31592-6" TargetMode="Externa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ar-SY" sz="4800" dirty="0">
                <a:solidFill>
                  <a:schemeClr val="accent2">
                    <a:lumMod val="50000"/>
                  </a:schemeClr>
                </a:solidFill>
                <a:latin typeface="Simplified Arabic" panose="02020603050405020304" pitchFamily="18" charset="-78"/>
                <a:cs typeface="Simplified Arabic" panose="02020603050405020304" pitchFamily="18" charset="-78"/>
              </a:rPr>
              <a:t>الطب المسند بالدليل في ظروف العمل السريري</a:t>
            </a:r>
            <a:endParaRPr lang="en-US" sz="4800" dirty="0">
              <a:solidFill>
                <a:schemeClr val="accent2">
                  <a:lumMod val="50000"/>
                </a:schemeClr>
              </a:solidFill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pPr rtl="1"/>
            <a:r>
              <a:rPr lang="ar-SY" sz="5400" dirty="0">
                <a:solidFill>
                  <a:schemeClr val="accent3">
                    <a:lumMod val="75000"/>
                  </a:schemeClr>
                </a:solidFill>
              </a:rPr>
              <a:t>الوحدة الثالثة</a:t>
            </a:r>
          </a:p>
          <a:p>
            <a:r>
              <a:rPr lang="ar-SY" sz="3200" dirty="0"/>
              <a:t>التقييم النقدي</a:t>
            </a:r>
            <a:endParaRPr lang="en-US" sz="32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398748"/>
            <a:ext cx="2479677" cy="196340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6345382" y="799197"/>
            <a:ext cx="4322618" cy="1261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rtl="1"/>
            <a:r>
              <a:rPr lang="ar-SY" sz="2800" b="1" dirty="0">
                <a:latin typeface="Simplified Arabic" panose="02020603050405020304" pitchFamily="18" charset="-78"/>
                <a:cs typeface="Simplified Arabic" panose="02020603050405020304" pitchFamily="18" charset="-78"/>
              </a:rPr>
              <a:t>الجامعة الافتراضية السورية</a:t>
            </a:r>
          </a:p>
          <a:p>
            <a:pPr algn="r" rtl="1"/>
            <a:endParaRPr lang="ar-SY" sz="2000" dirty="0"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  <a:p>
            <a:pPr algn="r" rtl="1"/>
            <a:r>
              <a:rPr lang="ar-SY" sz="2800" b="1" dirty="0">
                <a:latin typeface="Simplified Arabic" panose="02020603050405020304" pitchFamily="18" charset="-78"/>
                <a:cs typeface="Simplified Arabic" panose="02020603050405020304" pitchFamily="18" charset="-78"/>
              </a:rPr>
              <a:t>ماجستير التعليم الطبي</a:t>
            </a:r>
            <a:endParaRPr lang="en-US" sz="2800" b="1" dirty="0">
              <a:latin typeface="Simplified Arabic" panose="02020603050405020304" pitchFamily="18" charset="-78"/>
              <a:cs typeface="Simplified Arabic" panose="02020603050405020304" pitchFamily="18" charset="-78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8936183" y="5349873"/>
            <a:ext cx="173181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ar-SY" sz="2800" dirty="0"/>
              <a:t>إعداد وتقديم:</a:t>
            </a:r>
            <a:br>
              <a:rPr lang="ar-SY" sz="2800" dirty="0"/>
            </a:br>
            <a:r>
              <a:rPr lang="ar-SY" sz="2800" dirty="0"/>
              <a:t>يزن قنجراوي</a:t>
            </a:r>
            <a:endParaRPr 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1524000" y="5351891"/>
            <a:ext cx="2331087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ar-SY" sz="2800" dirty="0"/>
              <a:t>بإشراف:</a:t>
            </a:r>
            <a:br>
              <a:rPr lang="ar-SY" sz="2800" dirty="0"/>
            </a:br>
            <a:r>
              <a:rPr lang="ar-SY" sz="2800" dirty="0"/>
              <a:t>أ. د. ميسون دشاش</a:t>
            </a:r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206770045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76D3D7-05EC-4FA8-9084-B85576DAD0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هرم الأدلة العلم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1528AD-3D38-408B-842E-5C9DA53127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pPr algn="just" rtl="1"/>
            <a:r>
              <a:rPr lang="ar-SY" sz="3600" dirty="0"/>
              <a:t>دراسة مراقبة الحالات والشواهد:</a:t>
            </a:r>
          </a:p>
          <a:p>
            <a:pPr algn="just" rtl="1"/>
            <a:r>
              <a:rPr lang="ar-SY" dirty="0"/>
              <a:t>دراسة مراقبة </a:t>
            </a:r>
            <a:r>
              <a:rPr lang="en-US" dirty="0"/>
              <a:t>Observation Study</a:t>
            </a:r>
          </a:p>
          <a:p>
            <a:pPr algn="just" rtl="1"/>
            <a:r>
              <a:rPr lang="ar-SY" dirty="0"/>
              <a:t>دراسة بأثر رجعي </a:t>
            </a:r>
            <a:r>
              <a:rPr lang="en-US" dirty="0"/>
              <a:t>Retrospective</a:t>
            </a:r>
            <a:endParaRPr lang="ar-SY" dirty="0"/>
          </a:p>
          <a:p>
            <a:pPr algn="just" rtl="1"/>
            <a:r>
              <a:rPr lang="ar-SY" dirty="0"/>
              <a:t>تطابق في المجموعتين في الحد الأقصى إلا من حيث الحالة</a:t>
            </a:r>
            <a:endParaRPr lang="en-US" dirty="0"/>
          </a:p>
          <a:p>
            <a:pPr algn="just" rtl="1"/>
            <a:r>
              <a:rPr lang="ar-SY" dirty="0"/>
              <a:t>مجموعة شاهدة</a:t>
            </a:r>
          </a:p>
          <a:p>
            <a:pPr algn="just" rtl="1"/>
            <a:r>
              <a:rPr lang="ar-SY" dirty="0"/>
              <a:t>قليلة التكاليف</a:t>
            </a:r>
          </a:p>
          <a:p>
            <a:pPr algn="just" rtl="1"/>
            <a:r>
              <a:rPr lang="ar-SY" dirty="0"/>
              <a:t>جيدة لدراسة الأمراض النادرة.</a:t>
            </a:r>
          </a:p>
          <a:p>
            <a:pPr algn="just" rtl="1"/>
            <a:r>
              <a:rPr lang="ar-SY" dirty="0"/>
              <a:t>مشكلة التحيز في التذكّر (</a:t>
            </a:r>
            <a:r>
              <a:rPr lang="en-US" dirty="0"/>
              <a:t>recall bias</a:t>
            </a:r>
            <a:r>
              <a:rPr lang="ar-SY" dirty="0"/>
              <a:t>)</a:t>
            </a:r>
          </a:p>
          <a:p>
            <a:pPr marL="0" lvl="0" indent="0" algn="just" rtl="1">
              <a:buNone/>
            </a:pPr>
            <a:r>
              <a:rPr lang="en-US" sz="2000" dirty="0">
                <a:solidFill>
                  <a:prstClr val="black"/>
                </a:solidFill>
              </a:rPr>
              <a:t>(Designs, 2014)</a:t>
            </a:r>
          </a:p>
          <a:p>
            <a:pPr algn="just" rtl="1"/>
            <a:endParaRPr lang="en-US" dirty="0"/>
          </a:p>
          <a:p>
            <a:pPr algn="just" rtl="1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5536413-ACE0-4776-B7DC-6E01D2F2F8B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3840480"/>
            <a:ext cx="5088182" cy="2849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878675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6AE9BB-F3B5-40D0-98E5-F2D58BB712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هرم الأدلة العلمية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6C360AE-E704-49E0-A1D3-A4A0F1B4B6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just" rtl="1"/>
            <a:r>
              <a:rPr lang="ar-SY" sz="3600" dirty="0"/>
              <a:t>تقارير الحالات:</a:t>
            </a:r>
          </a:p>
          <a:p>
            <a:pPr algn="just" rtl="1"/>
            <a:r>
              <a:rPr lang="ar-SY" dirty="0"/>
              <a:t>ممتازة لوصف الحالات النادرة.</a:t>
            </a:r>
          </a:p>
          <a:p>
            <a:pPr algn="just" rtl="1"/>
            <a:r>
              <a:rPr lang="ar-SY" dirty="0"/>
              <a:t>توليد الفرضيات.</a:t>
            </a:r>
          </a:p>
          <a:p>
            <a:pPr marL="0" indent="0" algn="just" rtl="1">
              <a:buNone/>
            </a:pPr>
            <a:r>
              <a:rPr lang="ar-SY" sz="3200" b="1" dirty="0"/>
              <a:t>السلبيات:</a:t>
            </a:r>
          </a:p>
          <a:p>
            <a:pPr algn="just" rtl="1"/>
            <a:r>
              <a:rPr lang="ar-SY" dirty="0"/>
              <a:t>زمن قصير</a:t>
            </a:r>
          </a:p>
          <a:p>
            <a:pPr algn="just" rtl="1"/>
            <a:r>
              <a:rPr lang="ar-SY" dirty="0"/>
              <a:t>الاختيار الذاتي للقائمين على الدراسة (تحيز!)</a:t>
            </a:r>
          </a:p>
          <a:p>
            <a:pPr algn="just" rtl="1"/>
            <a:r>
              <a:rPr lang="ar-SY" dirty="0"/>
              <a:t>لا توجد مجموعة شاهدة بشكل عام</a:t>
            </a:r>
          </a:p>
          <a:p>
            <a:pPr marL="0" lvl="0" indent="0" algn="just" rtl="1">
              <a:buNone/>
            </a:pPr>
            <a:r>
              <a:rPr lang="en-US" sz="2000" dirty="0">
                <a:solidFill>
                  <a:prstClr val="black"/>
                </a:solidFill>
              </a:rPr>
              <a:t>(Designs, 2014)</a:t>
            </a:r>
          </a:p>
          <a:p>
            <a:pPr algn="just" rtl="1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245829F-00C7-44F7-BA9F-8F2B252C880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1825625"/>
            <a:ext cx="3176002" cy="33650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089353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A5347FA0-C1A2-4A47-99F4-591703872F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8979" y="260581"/>
            <a:ext cx="8834042" cy="63368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658315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EDE823-6AA5-4941-B540-3A29A07C2C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المراجع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9DED49-371E-4AC7-B4B7-B8150B7B56F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err="1"/>
              <a:t>Akobeng</a:t>
            </a:r>
            <a:r>
              <a:rPr lang="en-US" dirty="0"/>
              <a:t>, A. K. (2005). Principles of evidence based medicine. </a:t>
            </a:r>
            <a:r>
              <a:rPr lang="en-US" i="1" dirty="0"/>
              <a:t>Archives of Disease in Childhood</a:t>
            </a:r>
            <a:r>
              <a:rPr lang="en-US" dirty="0"/>
              <a:t>, </a:t>
            </a:r>
            <a:r>
              <a:rPr lang="en-US" i="1" dirty="0"/>
              <a:t>90</a:t>
            </a:r>
            <a:r>
              <a:rPr lang="en-US" dirty="0"/>
              <a:t>(8), 837–840. https://doi.org/10.1136/adc.2005.071761</a:t>
            </a:r>
          </a:p>
          <a:p>
            <a:r>
              <a:rPr lang="en-US" dirty="0"/>
              <a:t>Designs, S. (2014). </a:t>
            </a:r>
            <a:r>
              <a:rPr lang="en-US" i="1" dirty="0"/>
              <a:t>Study designs in medical research</a:t>
            </a:r>
            <a:r>
              <a:rPr lang="en-US" dirty="0"/>
              <a:t>.</a:t>
            </a:r>
          </a:p>
          <a:p>
            <a:r>
              <a:rPr lang="en-US" dirty="0" err="1"/>
              <a:t>Djulbegovic</a:t>
            </a:r>
            <a:r>
              <a:rPr lang="en-US" dirty="0"/>
              <a:t>, B., &amp; </a:t>
            </a:r>
            <a:r>
              <a:rPr lang="en-US" dirty="0" err="1"/>
              <a:t>Guyatt</a:t>
            </a:r>
            <a:r>
              <a:rPr lang="en-US" dirty="0"/>
              <a:t>, G. H. (2017). Progress in evidence-based medicine: a quarter century on. </a:t>
            </a:r>
            <a:r>
              <a:rPr lang="en-US" i="1" dirty="0"/>
              <a:t>The Lancet</a:t>
            </a:r>
            <a:r>
              <a:rPr lang="en-US" dirty="0"/>
              <a:t>, </a:t>
            </a:r>
            <a:r>
              <a:rPr lang="en-US" i="1" dirty="0"/>
              <a:t>390</a:t>
            </a:r>
            <a:r>
              <a:rPr lang="en-US" dirty="0"/>
              <a:t>(10092), 415–423. </a:t>
            </a:r>
            <a:r>
              <a:rPr lang="en-US" dirty="0">
                <a:hlinkClick r:id="rId2"/>
              </a:rPr>
              <a:t>https://doi.org/10.1016/S0140-6736(16)31592-6</a:t>
            </a:r>
            <a:endParaRPr lang="en-US" dirty="0"/>
          </a:p>
          <a:p>
            <a:r>
              <a:rPr lang="en-US" dirty="0" err="1"/>
              <a:t>Glasziou</a:t>
            </a:r>
            <a:r>
              <a:rPr lang="en-US" dirty="0"/>
              <a:t>, P., Burls, A., &amp; Gilbert, R. (2008). Evidence based medicine and the medical curriculum. </a:t>
            </a:r>
            <a:r>
              <a:rPr lang="en-US" i="1" dirty="0" err="1"/>
              <a:t>Bmj</a:t>
            </a:r>
            <a:r>
              <a:rPr lang="en-US" dirty="0"/>
              <a:t>, </a:t>
            </a:r>
            <a:r>
              <a:rPr lang="en-US" i="1" dirty="0"/>
              <a:t>337</a:t>
            </a:r>
            <a:r>
              <a:rPr lang="en-US" dirty="0"/>
              <a:t>(7672), 704–705. https://doi.org/10.1136/bmj.a1253</a:t>
            </a:r>
          </a:p>
          <a:p>
            <a:endParaRPr lang="en-US" dirty="0"/>
          </a:p>
          <a:p>
            <a:endParaRPr lang="ar-SY" dirty="0"/>
          </a:p>
        </p:txBody>
      </p:sp>
    </p:spTree>
    <p:extLst>
      <p:ext uri="{BB962C8B-B14F-4D97-AF65-F5344CB8AC3E}">
        <p14:creationId xmlns:p14="http://schemas.microsoft.com/office/powerpoint/2010/main" val="39820810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 rtl="1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الأهداف التعليمية:</a:t>
            </a:r>
            <a:endParaRPr lang="en-US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r" rtl="1"/>
            <a:r>
              <a:rPr lang="ar-SY" sz="3600" dirty="0"/>
              <a:t>عند الانتهاء من هذه الوحدة ستكون قادر على:</a:t>
            </a:r>
          </a:p>
          <a:p>
            <a:pPr algn="r" rtl="1">
              <a:lnSpc>
                <a:spcPct val="200000"/>
              </a:lnSpc>
            </a:pPr>
            <a:r>
              <a:rPr lang="ar-SY" dirty="0"/>
              <a:t>1)</a:t>
            </a:r>
            <a:r>
              <a:rPr lang="ar-SY" b="1" dirty="0"/>
              <a:t> تقييم الدراسات بشكل نقدي.</a:t>
            </a:r>
            <a:br>
              <a:rPr lang="ar-SY" dirty="0"/>
            </a:br>
            <a:r>
              <a:rPr lang="ar-SY" dirty="0"/>
              <a:t>2) تعريف مفهوم تطبيق الأدلة العلمية.</a:t>
            </a:r>
            <a:br>
              <a:rPr lang="ar-SY" dirty="0"/>
            </a:br>
            <a:r>
              <a:rPr lang="ar-SY" dirty="0"/>
              <a:t>3) تعريف مفهوم تقويم مراحل الطب المسند بالدليل. </a:t>
            </a:r>
            <a:br>
              <a:rPr lang="ar-SY" dirty="0"/>
            </a:b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2615803"/>
            <a:ext cx="4164042" cy="2770981"/>
          </a:xfrm>
          <a:prstGeom prst="rect">
            <a:avLst/>
          </a:prstGeom>
          <a:solidFill>
            <a:srgbClr val="FFFFFF">
              <a:shade val="85000"/>
            </a:srgbClr>
          </a:solidFill>
          <a:ln w="190500" cap="sq">
            <a:solidFill>
              <a:srgbClr val="FFFFFF"/>
            </a:solidFill>
            <a:miter lim="800000"/>
          </a:ln>
          <a:effectLst>
            <a:outerShdw blurRad="55000" dist="18000" dir="54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twoPt" dir="t">
              <a:rot lat="0" lon="0" rev="7200000"/>
            </a:lightRig>
          </a:scene3d>
          <a:sp3d>
            <a:bevelT w="25400" h="19050"/>
            <a:contourClr>
              <a:srgbClr val="FFFFFF"/>
            </a:contourClr>
          </a:sp3d>
        </p:spPr>
      </p:pic>
    </p:spTree>
    <p:extLst>
      <p:ext uri="{BB962C8B-B14F-4D97-AF65-F5344CB8AC3E}">
        <p14:creationId xmlns:p14="http://schemas.microsoft.com/office/powerpoint/2010/main" val="15047745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F8CD2F-A726-4737-9024-B8BF3CAE43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>
                    <a:lumMod val="75000"/>
                  </a:schemeClr>
                </a:solidFill>
              </a:rPr>
              <a:t>أهمية التقييم النقدي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4441B30-7EB6-44AC-9EF8-678FB9F20A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89894"/>
            <a:ext cx="10515600" cy="4351338"/>
          </a:xfrm>
        </p:spPr>
        <p:txBody>
          <a:bodyPr/>
          <a:lstStyle/>
          <a:p>
            <a:pPr algn="just" rtl="1"/>
            <a:r>
              <a:rPr lang="ar-SY" dirty="0"/>
              <a:t>مختلفة من حيث الجودة والقوة العلمية (المصداقية والموثوقية) والقدرة على تطبيقها في ظروفنا الخاصة، وتطبيق الأدلة الضعيفة أو التي لا تتناسب مع ظروفنا قد تكون مجرد هدر للموارد أو مؤذية. </a:t>
            </a:r>
            <a:r>
              <a:rPr lang="en-US" sz="2000" dirty="0"/>
              <a:t>(</a:t>
            </a:r>
            <a:r>
              <a:rPr lang="en-US" sz="2000" dirty="0" err="1"/>
              <a:t>Akobeng</a:t>
            </a:r>
            <a:r>
              <a:rPr lang="en-US" sz="2000" dirty="0"/>
              <a:t>, 2005)</a:t>
            </a:r>
            <a:endParaRPr lang="ar-SY" sz="2000" dirty="0"/>
          </a:p>
          <a:p>
            <a:pPr marL="0" indent="0" algn="just" rtl="1">
              <a:buNone/>
            </a:pPr>
            <a:r>
              <a:rPr lang="ar-SY" dirty="0"/>
              <a:t>إن طبيب القرن الحادي والعشرين الذي لا يستطيع تقييم دراسة بشكل نقدي هو غير جاهز كالطبيب الذي لا يستطيع قياس ضغط الدم ". </a:t>
            </a:r>
            <a:r>
              <a:rPr lang="en-US" sz="2000" dirty="0"/>
              <a:t>(</a:t>
            </a:r>
            <a:r>
              <a:rPr lang="en-US" sz="2000" dirty="0" err="1"/>
              <a:t>Glasziou</a:t>
            </a:r>
            <a:r>
              <a:rPr lang="en-US" sz="2000" dirty="0"/>
              <a:t> et al., 2008)</a:t>
            </a:r>
            <a:endParaRPr lang="ar-SY" sz="2000" dirty="0"/>
          </a:p>
          <a:p>
            <a:pPr algn="just" rtl="1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71E7800A-2775-4BB1-AE1F-A1CBFE587AD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4500" y="4065563"/>
            <a:ext cx="8763000" cy="27924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92884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674037-3F94-47CE-9B7C-423B0B48FD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هرم الأدلة العلمية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33971BBD-05FF-40EF-8E82-C1B3D310E860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499144107"/>
              </p:ext>
            </p:extLst>
          </p:nvPr>
        </p:nvGraphicFramePr>
        <p:xfrm>
          <a:off x="3882682" y="1690689"/>
          <a:ext cx="7471117" cy="448627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5" name="Up Arrow 10">
            <a:extLst>
              <a:ext uri="{FF2B5EF4-FFF2-40B4-BE49-F238E27FC236}">
                <a16:creationId xmlns:a16="http://schemas.microsoft.com/office/drawing/2014/main" id="{27C768A2-C3E7-478D-AF1C-F3C8F8A9F2FC}"/>
              </a:ext>
            </a:extLst>
          </p:cNvPr>
          <p:cNvSpPr/>
          <p:nvPr/>
        </p:nvSpPr>
        <p:spPr>
          <a:xfrm>
            <a:off x="450166" y="1913204"/>
            <a:ext cx="1937971" cy="4263757"/>
          </a:xfrm>
          <a:prstGeom prst="upArrow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0" marR="0" algn="ctr" rtl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ar-SY" sz="2800" b="1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قوة الأدلة العلمية</a:t>
            </a:r>
            <a:endParaRPr lang="en-US" sz="2000" b="1" dirty="0"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: Rounded Corners 5">
            <a:extLst>
              <a:ext uri="{FF2B5EF4-FFF2-40B4-BE49-F238E27FC236}">
                <a16:creationId xmlns:a16="http://schemas.microsoft.com/office/drawing/2014/main" id="{5F650CF8-0BB1-4281-A709-87F19C08CF56}"/>
              </a:ext>
            </a:extLst>
          </p:cNvPr>
          <p:cNvSpPr/>
          <p:nvPr/>
        </p:nvSpPr>
        <p:spPr>
          <a:xfrm>
            <a:off x="8567225" y="6302250"/>
            <a:ext cx="3024553" cy="436099"/>
          </a:xfrm>
          <a:prstGeom prst="round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dirty="0"/>
              <a:t>(</a:t>
            </a:r>
            <a:r>
              <a:rPr lang="en-US" dirty="0" err="1"/>
              <a:t>Djulbegovic</a:t>
            </a:r>
            <a:r>
              <a:rPr lang="en-US" dirty="0"/>
              <a:t> &amp; </a:t>
            </a:r>
            <a:r>
              <a:rPr lang="en-US" dirty="0" err="1"/>
              <a:t>Guyatt</a:t>
            </a:r>
            <a:r>
              <a:rPr lang="en-US" dirty="0"/>
              <a:t>, 2017)</a:t>
            </a:r>
            <a:endParaRPr lang="ar-SY" dirty="0"/>
          </a:p>
        </p:txBody>
      </p:sp>
      <p:sp>
        <p:nvSpPr>
          <p:cNvPr id="7" name="Arrow: Down 6">
            <a:extLst>
              <a:ext uri="{FF2B5EF4-FFF2-40B4-BE49-F238E27FC236}">
                <a16:creationId xmlns:a16="http://schemas.microsoft.com/office/drawing/2014/main" id="{85F5DAD3-AEA2-4406-9371-D93AE533009C}"/>
              </a:ext>
            </a:extLst>
          </p:cNvPr>
          <p:cNvSpPr/>
          <p:nvPr/>
        </p:nvSpPr>
        <p:spPr>
          <a:xfrm>
            <a:off x="2296697" y="1913204"/>
            <a:ext cx="1937970" cy="4263757"/>
          </a:xfrm>
          <a:prstGeom prst="downArrow">
            <a:avLst/>
          </a:prstGeom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ar-SA" sz="2800" b="1" dirty="0"/>
              <a:t>تزايد</a:t>
            </a:r>
            <a:r>
              <a:rPr lang="ar-SA" b="1" dirty="0"/>
              <a:t> خطر التحيز</a:t>
            </a:r>
            <a:endParaRPr lang="ar-SY" b="1" dirty="0"/>
          </a:p>
        </p:txBody>
      </p:sp>
    </p:spTree>
    <p:extLst>
      <p:ext uri="{BB962C8B-B14F-4D97-AF65-F5344CB8AC3E}">
        <p14:creationId xmlns:p14="http://schemas.microsoft.com/office/powerpoint/2010/main" val="13050093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9AF267-B43B-4FA4-9E1A-93AEF09910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هرم الأدلة العلم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3FCA1B-9474-4102-B9EB-EBC226B7873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just" rtl="1"/>
            <a:r>
              <a:rPr lang="ar-SY" sz="3600" dirty="0"/>
              <a:t>التجارب العشوائية ذات المجموعة الشاهدة:</a:t>
            </a:r>
          </a:p>
          <a:p>
            <a:pPr algn="just" rtl="1"/>
            <a:endParaRPr lang="ar-SY" dirty="0"/>
          </a:p>
          <a:p>
            <a:pPr algn="just" rtl="1"/>
            <a:endParaRPr lang="ar-SY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E0261AD-4FE3-4E1F-9BE8-4C2D21348F7B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5906" y="2198478"/>
            <a:ext cx="8122920" cy="3605631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Rectangle: Rounded Corners 4">
            <a:extLst>
              <a:ext uri="{FF2B5EF4-FFF2-40B4-BE49-F238E27FC236}">
                <a16:creationId xmlns:a16="http://schemas.microsoft.com/office/drawing/2014/main" id="{C1041AFF-62D5-46AD-8B00-7F4FDCC47ABE}"/>
              </a:ext>
            </a:extLst>
          </p:cNvPr>
          <p:cNvSpPr/>
          <p:nvPr/>
        </p:nvSpPr>
        <p:spPr>
          <a:xfrm>
            <a:off x="9496278" y="5804109"/>
            <a:ext cx="2039816" cy="685507"/>
          </a:xfrm>
          <a:prstGeom prst="round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dirty="0"/>
              <a:t>(Designs, 2014)</a:t>
            </a:r>
          </a:p>
        </p:txBody>
      </p:sp>
    </p:spTree>
    <p:extLst>
      <p:ext uri="{BB962C8B-B14F-4D97-AF65-F5344CB8AC3E}">
        <p14:creationId xmlns:p14="http://schemas.microsoft.com/office/powerpoint/2010/main" val="2773167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DBE597-BB5E-4B79-B865-CFD8A719B9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هرم الأدلة العلم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6C5D7A-597D-42BC-8AE8-9FB4852E8C4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algn="just" rtl="1"/>
            <a:r>
              <a:rPr lang="ar-SY" sz="3600" dirty="0"/>
              <a:t>التجارب العشوائية ذات المجموعة الشاهدة:</a:t>
            </a:r>
          </a:p>
          <a:p>
            <a:pPr algn="just" rtl="1"/>
            <a:r>
              <a:rPr lang="ar-SY" dirty="0"/>
              <a:t>التجربة السريرية العشوائية هي تعتبر أقوى دليل في استنتاج السببية</a:t>
            </a:r>
          </a:p>
          <a:p>
            <a:pPr algn="just" rtl="1"/>
            <a:r>
              <a:rPr lang="ar-SY" dirty="0"/>
              <a:t>للإجابة على الأسئلة العلاجية والتشخيصية.</a:t>
            </a:r>
          </a:p>
          <a:p>
            <a:pPr algn="just" rtl="1"/>
            <a:r>
              <a:rPr lang="ar-SY" dirty="0"/>
              <a:t>تعمية أحادية</a:t>
            </a:r>
          </a:p>
          <a:p>
            <a:pPr algn="just" rtl="1"/>
            <a:r>
              <a:rPr lang="ar-SY" dirty="0"/>
              <a:t>تعمية ثنائية</a:t>
            </a:r>
          </a:p>
          <a:p>
            <a:pPr algn="just" rtl="1"/>
            <a:r>
              <a:rPr lang="ar-SY" dirty="0"/>
              <a:t>تعمية ثلاثية</a:t>
            </a:r>
          </a:p>
          <a:p>
            <a:pPr algn="just" rtl="1"/>
            <a:r>
              <a:rPr lang="ar-SY" dirty="0"/>
              <a:t>تكلفة عالية.</a:t>
            </a:r>
          </a:p>
          <a:p>
            <a:pPr marL="0" indent="0" algn="just" rtl="1">
              <a:buNone/>
            </a:pPr>
            <a:r>
              <a:rPr lang="en-US" sz="2000" dirty="0"/>
              <a:t>(Designs, 2014)</a:t>
            </a:r>
          </a:p>
          <a:p>
            <a:pPr algn="just" rtl="1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99131AE-DF4E-48E8-A05E-A47E49AAE4B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7550" y="2326960"/>
            <a:ext cx="5108450" cy="51084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18989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F9B5FC-9163-429E-AE9A-6D8DA16BDF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هرم الأدلة العلم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1496A4-2D19-47A2-8C31-BCD9C07ACE5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just" rtl="1"/>
            <a:r>
              <a:rPr lang="ar-SY" sz="3600" dirty="0"/>
              <a:t>الدراسات الحشدية:</a:t>
            </a:r>
          </a:p>
          <a:p>
            <a:pPr algn="just" rtl="1"/>
            <a:endParaRPr lang="ar-SY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48AE53D-EEF0-4490-A6FF-7F589CC9B9E4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1520" y="1546952"/>
            <a:ext cx="7540283" cy="4908684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Rectangle: Rounded Corners 4">
            <a:extLst>
              <a:ext uri="{FF2B5EF4-FFF2-40B4-BE49-F238E27FC236}">
                <a16:creationId xmlns:a16="http://schemas.microsoft.com/office/drawing/2014/main" id="{762DA69D-1109-462A-BB70-07A2E276AA9B}"/>
              </a:ext>
            </a:extLst>
          </p:cNvPr>
          <p:cNvSpPr/>
          <p:nvPr/>
        </p:nvSpPr>
        <p:spPr>
          <a:xfrm>
            <a:off x="9313984" y="5770129"/>
            <a:ext cx="2039816" cy="685507"/>
          </a:xfrm>
          <a:prstGeom prst="round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dirty="0"/>
              <a:t>(Designs, 2014)</a:t>
            </a:r>
          </a:p>
        </p:txBody>
      </p:sp>
    </p:spTree>
    <p:extLst>
      <p:ext uri="{BB962C8B-B14F-4D97-AF65-F5344CB8AC3E}">
        <p14:creationId xmlns:p14="http://schemas.microsoft.com/office/powerpoint/2010/main" val="201395470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088212-5F7A-40FA-87CB-66E5920CD3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هرم الأدلة العلم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B8EB40-BAA9-4AA7-A49A-F540C183D94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just" rtl="1"/>
            <a:r>
              <a:rPr lang="ar-SY" sz="3600" dirty="0"/>
              <a:t>الدراسات الحشدية:</a:t>
            </a:r>
          </a:p>
          <a:p>
            <a:pPr algn="just" rtl="1"/>
            <a:r>
              <a:rPr lang="ar-SY" dirty="0"/>
              <a:t>دراسة مراقبة </a:t>
            </a:r>
            <a:r>
              <a:rPr lang="en-US" dirty="0"/>
              <a:t>Observational Study</a:t>
            </a:r>
            <a:endParaRPr lang="ar-SY" dirty="0"/>
          </a:p>
          <a:p>
            <a:pPr algn="just" rtl="1"/>
            <a:r>
              <a:rPr lang="ar-SY" dirty="0"/>
              <a:t>دراسة مستقبلية </a:t>
            </a:r>
            <a:r>
              <a:rPr lang="en-US" dirty="0"/>
              <a:t>Prospective</a:t>
            </a:r>
          </a:p>
          <a:p>
            <a:pPr algn="just" rtl="1"/>
            <a:r>
              <a:rPr lang="ar-SY" dirty="0"/>
              <a:t>للإجابة على أسئلة الإنذار والسببية الإمراضية.</a:t>
            </a:r>
          </a:p>
          <a:p>
            <a:pPr algn="just" rtl="1"/>
            <a:r>
              <a:rPr lang="ar-SY" dirty="0"/>
              <a:t>بحاجة إلى موارد مادية وزمنية كبيرة.</a:t>
            </a:r>
          </a:p>
          <a:p>
            <a:pPr algn="just" rtl="1"/>
            <a:r>
              <a:rPr lang="ar-SY" dirty="0"/>
              <a:t>المطابقة بين المجموعتين إلى أقصى حد ما عدا التعرض الذي يتم دراسته.</a:t>
            </a:r>
          </a:p>
          <a:p>
            <a:pPr algn="just" rtl="1"/>
            <a:r>
              <a:rPr lang="ar-SY" dirty="0"/>
              <a:t>جيدة لدراسة </a:t>
            </a:r>
            <a:r>
              <a:rPr lang="ar-SY" dirty="0" err="1"/>
              <a:t>التعرّضات</a:t>
            </a:r>
            <a:r>
              <a:rPr lang="ar-SY" dirty="0"/>
              <a:t> النادرة.</a:t>
            </a:r>
          </a:p>
          <a:p>
            <a:pPr marL="0" lvl="0" indent="0" algn="just" rtl="1">
              <a:buNone/>
            </a:pPr>
            <a:r>
              <a:rPr lang="en-US" sz="2000" dirty="0">
                <a:solidFill>
                  <a:prstClr val="black"/>
                </a:solidFill>
              </a:rPr>
              <a:t>(Designs, 2014)</a:t>
            </a:r>
          </a:p>
          <a:p>
            <a:pPr algn="just" rtl="1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2CC50CE1-C97B-4CA6-AF48-08D084D3CA6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4637" y="1825625"/>
            <a:ext cx="3953256" cy="25916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664001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70DF1D-DA3F-4508-AB35-1183413037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ar-SY" dirty="0">
                <a:solidFill>
                  <a:schemeClr val="accent1"/>
                </a:solidFill>
              </a:rPr>
              <a:t>هرم الأدلة العلمية</a:t>
            </a:r>
            <a:endParaRPr lang="ar-SY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6CD8E6-53C3-46C7-ACFA-DBCC0D7038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algn="just" rtl="1"/>
            <a:r>
              <a:rPr lang="ar-SY" sz="3600" dirty="0"/>
              <a:t>دراسة مراقبة الحالات والشواهد:</a:t>
            </a:r>
          </a:p>
          <a:p>
            <a:pPr algn="just" rtl="1"/>
            <a:endParaRPr lang="ar-SY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B2947D6-844B-46F1-A54F-62CEBB304BA2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327380"/>
            <a:ext cx="9762978" cy="4494627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F9A77CC1-E53A-46F2-9F8D-00AE5219D181}"/>
              </a:ext>
            </a:extLst>
          </p:cNvPr>
          <p:cNvSpPr/>
          <p:nvPr/>
        </p:nvSpPr>
        <p:spPr>
          <a:xfrm>
            <a:off x="9003323" y="5831974"/>
            <a:ext cx="2039816" cy="685507"/>
          </a:xfrm>
          <a:prstGeom prst="roundRect">
            <a:avLst/>
          </a:prstGeom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1" anchor="ctr"/>
          <a:lstStyle/>
          <a:p>
            <a:pPr algn="ctr"/>
            <a:r>
              <a:rPr lang="en-US" dirty="0"/>
              <a:t>(Designs, 2014)</a:t>
            </a:r>
          </a:p>
        </p:txBody>
      </p:sp>
    </p:spTree>
    <p:extLst>
      <p:ext uri="{BB962C8B-B14F-4D97-AF65-F5344CB8AC3E}">
        <p14:creationId xmlns:p14="http://schemas.microsoft.com/office/powerpoint/2010/main" val="37096821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3</TotalTime>
  <Words>526</Words>
  <Application>Microsoft Office PowerPoint</Application>
  <PresentationFormat>Widescreen</PresentationFormat>
  <Paragraphs>77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8" baseType="lpstr">
      <vt:lpstr>Arial</vt:lpstr>
      <vt:lpstr>Calibri</vt:lpstr>
      <vt:lpstr>Calibri Light</vt:lpstr>
      <vt:lpstr>Simplified Arabic</vt:lpstr>
      <vt:lpstr>Office Theme</vt:lpstr>
      <vt:lpstr>الطب المسند بالدليل في ظروف العمل السريري</vt:lpstr>
      <vt:lpstr>الأهداف التعليمية:</vt:lpstr>
      <vt:lpstr>أهمية التقييم النقدي</vt:lpstr>
      <vt:lpstr>هرم الأدلة العلمية</vt:lpstr>
      <vt:lpstr>هرم الأدلة العلمية</vt:lpstr>
      <vt:lpstr>هرم الأدلة العلمية</vt:lpstr>
      <vt:lpstr>هرم الأدلة العلمية</vt:lpstr>
      <vt:lpstr>هرم الأدلة العلمية</vt:lpstr>
      <vt:lpstr>هرم الأدلة العلمية</vt:lpstr>
      <vt:lpstr>هرم الأدلة العلمية</vt:lpstr>
      <vt:lpstr>هرم الأدلة العلمية</vt:lpstr>
      <vt:lpstr>PowerPoint Presentation</vt:lpstr>
      <vt:lpstr>المراجع</vt:lpstr>
    </vt:vector>
  </TitlesOfParts>
  <Company>SAC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الطب المسند بالدليل في ظروف العمل السريري</dc:title>
  <dc:creator>Maher Fattouh</dc:creator>
  <cp:lastModifiedBy>Yazan Kenjrawi</cp:lastModifiedBy>
  <cp:revision>28</cp:revision>
  <dcterms:created xsi:type="dcterms:W3CDTF">2021-05-07T13:07:52Z</dcterms:created>
  <dcterms:modified xsi:type="dcterms:W3CDTF">2021-06-15T20:46:26Z</dcterms:modified>
</cp:coreProperties>
</file>